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  <p:sldId id="297" r:id="rId4"/>
    <p:sldId id="305" r:id="rId5"/>
    <p:sldId id="257" r:id="rId6"/>
    <p:sldId id="300" r:id="rId7"/>
    <p:sldId id="302" r:id="rId8"/>
    <p:sldId id="303" r:id="rId9"/>
    <p:sldId id="30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27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novo\Desktop\elis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2032481000199"/>
          <c:y val="0.10277504874924226"/>
          <c:w val="0.73508097027087305"/>
          <c:h val="0.6806884433563451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W$17:$W$18</c:f>
              <c:strCache>
                <c:ptCount val="2"/>
                <c:pt idx="0">
                  <c:v>0.167</c:v>
                </c:pt>
                <c:pt idx="1">
                  <c:v>0.158</c:v>
                </c:pt>
              </c:strCache>
            </c:strRef>
          </c:tx>
          <c:spPr>
            <a:ln w="22225" cap="rnd">
              <a:solidFill>
                <a:schemeClr val="accent1"/>
              </a:solidFill>
            </a:ln>
            <a:effectLst>
              <a:glow rad="139700">
                <a:schemeClr val="accent1">
                  <a:satMod val="175000"/>
                  <a:alpha val="14000"/>
                </a:schemeClr>
              </a:glow>
            </a:effectLst>
          </c:spPr>
          <c:marker>
            <c:symbol val="circle"/>
            <c:size val="3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>
                <a:glow rad="63500">
                  <a:schemeClr val="accent1">
                    <a:satMod val="175000"/>
                    <a:alpha val="25000"/>
                  </a:schemeClr>
                </a:glow>
              </a:effectLst>
            </c:spPr>
          </c:marker>
          <c:xVal>
            <c:numRef>
              <c:f>Sheet1!$V$19:$V$24</c:f>
              <c:numCache>
                <c:formatCode>General</c:formatCode>
                <c:ptCount val="6"/>
                <c:pt idx="0">
                  <c:v>250</c:v>
                </c:pt>
                <c:pt idx="1">
                  <c:v>500</c:v>
                </c:pt>
                <c:pt idx="2">
                  <c:v>1000</c:v>
                </c:pt>
                <c:pt idx="3">
                  <c:v>2500</c:v>
                </c:pt>
                <c:pt idx="4">
                  <c:v>5000</c:v>
                </c:pt>
                <c:pt idx="5">
                  <c:v>10000</c:v>
                </c:pt>
              </c:numCache>
            </c:numRef>
          </c:xVal>
          <c:yVal>
            <c:numRef>
              <c:f>Sheet1!$W$19:$W$24</c:f>
              <c:numCache>
                <c:formatCode>General</c:formatCode>
                <c:ptCount val="6"/>
                <c:pt idx="0">
                  <c:v>0.433</c:v>
                </c:pt>
                <c:pt idx="1">
                  <c:v>0.35199999999999998</c:v>
                </c:pt>
                <c:pt idx="2">
                  <c:v>0.253</c:v>
                </c:pt>
                <c:pt idx="3">
                  <c:v>0.23699999999999999</c:v>
                </c:pt>
                <c:pt idx="4">
                  <c:v>0.192</c:v>
                </c:pt>
                <c:pt idx="5">
                  <c:v>0.173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1D-4FCB-B49B-8F354C45B7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5248128"/>
        <c:axId val="2095244384"/>
      </c:scatterChart>
      <c:valAx>
        <c:axId val="20952481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65000"/>
                  <a:lumOff val="35000"/>
                  <a:alpha val="7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lt1">
                    <a:lumMod val="7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95244384"/>
        <c:crosses val="autoZero"/>
        <c:crossBetween val="midCat"/>
      </c:valAx>
      <c:valAx>
        <c:axId val="20952443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65000"/>
                  <a:lumOff val="35000"/>
                  <a:alpha val="7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lt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lt1">
                    <a:lumMod val="7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952481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dk1">
        <a:lumMod val="75000"/>
        <a:lumOff val="25000"/>
      </a:schemeClr>
    </a:soli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4663968291535"/>
          <c:y val="0.20118610713784466"/>
          <c:w val="0.81234902060853509"/>
          <c:h val="0.52287214098237722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P$2:$P$3</c:f>
              <c:strCache>
                <c:ptCount val="2"/>
                <c:pt idx="0">
                  <c:v>0.183</c:v>
                </c:pt>
                <c:pt idx="1">
                  <c:v>0.2</c:v>
                </c:pt>
              </c:strCache>
            </c:strRef>
          </c:tx>
          <c:spPr>
            <a:ln w="22225" cap="rnd">
              <a:solidFill>
                <a:schemeClr val="accent1"/>
              </a:solidFill>
            </a:ln>
            <a:effectLst>
              <a:glow rad="139700">
                <a:schemeClr val="accent1">
                  <a:satMod val="175000"/>
                  <a:alpha val="14000"/>
                </a:schemeClr>
              </a:glow>
            </a:effectLst>
          </c:spPr>
          <c:marker>
            <c:symbol val="circle"/>
            <c:size val="3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>
                <a:glow rad="63500">
                  <a:schemeClr val="accent1">
                    <a:satMod val="175000"/>
                    <a:alpha val="25000"/>
                  </a:schemeClr>
                </a:glow>
              </a:effectLst>
            </c:spPr>
          </c:marker>
          <c:xVal>
            <c:numRef>
              <c:f>Sheet1!$O$4:$O$9</c:f>
              <c:numCache>
                <c:formatCode>General</c:formatCode>
                <c:ptCount val="6"/>
                <c:pt idx="0">
                  <c:v>250</c:v>
                </c:pt>
                <c:pt idx="1">
                  <c:v>500</c:v>
                </c:pt>
                <c:pt idx="2">
                  <c:v>1000</c:v>
                </c:pt>
                <c:pt idx="3">
                  <c:v>2500</c:v>
                </c:pt>
                <c:pt idx="4">
                  <c:v>5000</c:v>
                </c:pt>
                <c:pt idx="5">
                  <c:v>10000</c:v>
                </c:pt>
              </c:numCache>
            </c:numRef>
          </c:xVal>
          <c:yVal>
            <c:numRef>
              <c:f>Sheet1!$P$4:$P$9</c:f>
              <c:numCache>
                <c:formatCode>General</c:formatCode>
                <c:ptCount val="6"/>
                <c:pt idx="0">
                  <c:v>0.68200000000000005</c:v>
                </c:pt>
                <c:pt idx="1">
                  <c:v>0.66100000000000003</c:v>
                </c:pt>
                <c:pt idx="2">
                  <c:v>0.49299999999999999</c:v>
                </c:pt>
                <c:pt idx="3">
                  <c:v>0.33900000000000002</c:v>
                </c:pt>
                <c:pt idx="4">
                  <c:v>0.33400000000000002</c:v>
                </c:pt>
                <c:pt idx="5">
                  <c:v>0.231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F79-41EA-ACEE-E87DC8333F97}"/>
            </c:ext>
          </c:extLst>
        </c:ser>
        <c:ser>
          <c:idx val="1"/>
          <c:order val="1"/>
          <c:tx>
            <c:strRef>
              <c:f>Sheet1!$Q$2:$Q$3</c:f>
              <c:strCache>
                <c:ptCount val="2"/>
                <c:pt idx="0">
                  <c:v>0.183</c:v>
                </c:pt>
                <c:pt idx="1">
                  <c:v>0.2</c:v>
                </c:pt>
              </c:strCache>
            </c:strRef>
          </c:tx>
          <c:spPr>
            <a:ln w="22225" cap="rnd">
              <a:solidFill>
                <a:schemeClr val="accent2"/>
              </a:solidFill>
            </a:ln>
            <a:effectLst>
              <a:glow rad="139700">
                <a:schemeClr val="accent2">
                  <a:satMod val="175000"/>
                  <a:alpha val="14000"/>
                </a:schemeClr>
              </a:glow>
            </a:effectLst>
          </c:spPr>
          <c:marker>
            <c:symbol val="circle"/>
            <c:size val="3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>
                <a:glow rad="63500">
                  <a:schemeClr val="accent2">
                    <a:satMod val="175000"/>
                    <a:alpha val="25000"/>
                  </a:schemeClr>
                </a:glow>
              </a:effectLst>
            </c:spPr>
          </c:marker>
          <c:xVal>
            <c:numRef>
              <c:f>Sheet1!$O$4:$O$9</c:f>
              <c:numCache>
                <c:formatCode>General</c:formatCode>
                <c:ptCount val="6"/>
                <c:pt idx="0">
                  <c:v>250</c:v>
                </c:pt>
                <c:pt idx="1">
                  <c:v>500</c:v>
                </c:pt>
                <c:pt idx="2">
                  <c:v>1000</c:v>
                </c:pt>
                <c:pt idx="3">
                  <c:v>2500</c:v>
                </c:pt>
                <c:pt idx="4">
                  <c:v>5000</c:v>
                </c:pt>
                <c:pt idx="5">
                  <c:v>10000</c:v>
                </c:pt>
              </c:numCache>
            </c:numRef>
          </c:xVal>
          <c:yVal>
            <c:numRef>
              <c:f>Sheet1!$Q$4:$Q$9</c:f>
              <c:numCache>
                <c:formatCode>General</c:formatCode>
                <c:ptCount val="6"/>
                <c:pt idx="0">
                  <c:v>0.69499999999999995</c:v>
                </c:pt>
                <c:pt idx="1">
                  <c:v>0.65400000000000003</c:v>
                </c:pt>
                <c:pt idx="2">
                  <c:v>0.47699999999999998</c:v>
                </c:pt>
                <c:pt idx="3">
                  <c:v>0.34200000000000003</c:v>
                </c:pt>
                <c:pt idx="4">
                  <c:v>0.32100000000000001</c:v>
                </c:pt>
                <c:pt idx="5">
                  <c:v>0.233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F79-41EA-ACEE-E87DC8333F97}"/>
            </c:ext>
          </c:extLst>
        </c:ser>
        <c:ser>
          <c:idx val="2"/>
          <c:order val="2"/>
          <c:tx>
            <c:strRef>
              <c:f>Sheet1!$R$2:$R$3</c:f>
              <c:strCache>
                <c:ptCount val="2"/>
                <c:pt idx="0">
                  <c:v>0.208</c:v>
                </c:pt>
                <c:pt idx="1">
                  <c:v>0.22</c:v>
                </c:pt>
              </c:strCache>
            </c:strRef>
          </c:tx>
          <c:spPr>
            <a:ln w="22225" cap="rnd">
              <a:solidFill>
                <a:schemeClr val="accent3"/>
              </a:solidFill>
            </a:ln>
            <a:effectLst>
              <a:glow rad="139700">
                <a:schemeClr val="accent3">
                  <a:satMod val="175000"/>
                  <a:alpha val="14000"/>
                </a:schemeClr>
              </a:glow>
            </a:effectLst>
          </c:spPr>
          <c:marker>
            <c:symbol val="circle"/>
            <c:size val="3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noFill/>
              </a:ln>
              <a:effectLst>
                <a:glow rad="63500">
                  <a:schemeClr val="accent3">
                    <a:satMod val="175000"/>
                    <a:alpha val="25000"/>
                  </a:schemeClr>
                </a:glow>
              </a:effectLst>
            </c:spPr>
          </c:marker>
          <c:xVal>
            <c:numRef>
              <c:f>Sheet1!$O$4:$O$9</c:f>
              <c:numCache>
                <c:formatCode>General</c:formatCode>
                <c:ptCount val="6"/>
                <c:pt idx="0">
                  <c:v>250</c:v>
                </c:pt>
                <c:pt idx="1">
                  <c:v>500</c:v>
                </c:pt>
                <c:pt idx="2">
                  <c:v>1000</c:v>
                </c:pt>
                <c:pt idx="3">
                  <c:v>2500</c:v>
                </c:pt>
                <c:pt idx="4">
                  <c:v>5000</c:v>
                </c:pt>
                <c:pt idx="5">
                  <c:v>10000</c:v>
                </c:pt>
              </c:numCache>
            </c:numRef>
          </c:xVal>
          <c:yVal>
            <c:numRef>
              <c:f>Sheet1!$R$4:$R$9</c:f>
              <c:numCache>
                <c:formatCode>General</c:formatCode>
                <c:ptCount val="6"/>
                <c:pt idx="0">
                  <c:v>0.69699999999999995</c:v>
                </c:pt>
                <c:pt idx="1">
                  <c:v>0.65500000000000003</c:v>
                </c:pt>
                <c:pt idx="2">
                  <c:v>0.48199999999999998</c:v>
                </c:pt>
                <c:pt idx="3">
                  <c:v>0.34</c:v>
                </c:pt>
                <c:pt idx="4">
                  <c:v>0.34699999999999998</c:v>
                </c:pt>
                <c:pt idx="5">
                  <c:v>0.2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F79-41EA-ACEE-E87DC8333F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66755872"/>
        <c:axId val="2066744640"/>
      </c:scatterChart>
      <c:valAx>
        <c:axId val="20667558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65000"/>
                  <a:lumOff val="35000"/>
                  <a:alpha val="7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lt1">
                    <a:lumMod val="7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66744640"/>
        <c:crosses val="autoZero"/>
        <c:crossBetween val="midCat"/>
      </c:valAx>
      <c:valAx>
        <c:axId val="20667446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65000"/>
                  <a:lumOff val="35000"/>
                  <a:alpha val="7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lt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lt1">
                    <a:lumMod val="7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667558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dk1">
        <a:lumMod val="75000"/>
        <a:lumOff val="25000"/>
      </a:schemeClr>
    </a:soli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5">
  <cs:axisTitle>
    <cs:lnRef idx="0"/>
    <cs:fillRef idx="0"/>
    <cs:effectRef idx="0"/>
    <cs:fontRef idx="minor">
      <a:schemeClr val="lt1">
        <a:lumMod val="75000"/>
      </a:schemeClr>
    </cs:fontRef>
    <cs:defRPr sz="900" b="1" kern="1200"/>
  </cs:axisTitle>
  <cs:categoryAxis>
    <cs:lnRef idx="0"/>
    <cs:fillRef idx="0"/>
    <cs:effectRef idx="0"/>
    <cs:fontRef idx="minor">
      <a:schemeClr val="lt1">
        <a:lumMod val="75000"/>
      </a:schemeClr>
    </cs:fontRef>
    <cs:defRPr sz="900" kern="1200"/>
  </cs:categoryAxis>
  <cs:chartArea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>
        <a:lumMod val="75000"/>
      </a:schemeClr>
    </cs:fontRef>
    <cs:defRPr sz="900" kern="1200"/>
  </cs:dataLabel>
  <cs:dataLabelCallout>
    <cs:lnRef idx="0"/>
    <cs:fillRef idx="0"/>
    <cs:effectRef idx="0"/>
    <cs:fontRef idx="minor">
      <a:schemeClr val="lt1">
        <a:lumMod val="15000"/>
        <a:lumOff val="85000"/>
      </a:schemeClr>
    </cs:fontRef>
    <cs:spPr>
      <a:solidFill>
        <a:schemeClr val="dk1">
          <a:lumMod val="65000"/>
          <a:lumOff val="3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/>
    <cs:effectRef idx="0">
      <cs:styleClr val="auto"/>
    </cs:effectRef>
    <cs:fontRef idx="minor">
      <a:schemeClr val="dk1"/>
    </cs:fontRef>
    <cs:spPr>
      <a:ln w="9525" cap="flat" cmpd="sng" algn="ctr">
        <a:solidFill>
          <a:schemeClr val="phClr"/>
        </a:solidFill>
        <a:miter lim="800000"/>
      </a:ln>
      <a:effectLst>
        <a:glow rad="63500">
          <a:schemeClr val="phClr">
            <a:satMod val="175000"/>
            <a:alpha val="25000"/>
          </a:schemeClr>
        </a:glow>
      </a:effectLst>
    </cs:spPr>
  </cs:dataPoint>
  <cs:dataPoint3D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ln w="9525" cap="flat" cmpd="sng" algn="ctr">
        <a:solidFill>
          <a:schemeClr val="phClr"/>
        </a:solidFill>
        <a:miter lim="800000"/>
      </a:ln>
      <a:effectLst>
        <a:glow rad="63500">
          <a:schemeClr val="phClr">
            <a:satMod val="175000"/>
            <a:alpha val="25000"/>
          </a:schemeClr>
        </a:glow>
      </a:effectLst>
    </cs:spPr>
  </cs:dataPoint3D>
  <cs:dataPointLine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ln w="22225" cap="rnd">
        <a:solidFill>
          <a:schemeClr val="phClr"/>
        </a:solidFill>
      </a:ln>
      <a:effectLst>
        <a:glow rad="139700">
          <a:schemeClr val="phClr">
            <a:satMod val="175000"/>
            <a:alpha val="14000"/>
          </a:schemeClr>
        </a:glow>
      </a:effectLst>
    </cs:spPr>
  </cs:dataPointLine>
  <cs:dataPointMarker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solidFill>
        <a:schemeClr val="phClr">
          <a:lumMod val="60000"/>
          <a:lumOff val="40000"/>
        </a:schemeClr>
      </a:solidFill>
      <a:effectLst>
        <a:glow rad="63500">
          <a:schemeClr val="phClr">
            <a:satMod val="175000"/>
            <a:alpha val="25000"/>
          </a:schemeClr>
        </a:glow>
      </a:effectLst>
    </cs:spPr>
  </cs:dataPointMarker>
  <cs:dataPointMarkerLayout symbol="circle" size="3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lt1">
        <a:lumMod val="75000"/>
      </a:schemeClr>
    </cs:fontRef>
    <cs:spPr>
      <a:ln w="9525">
        <a:solidFill>
          <a:schemeClr val="dk1">
            <a:lumMod val="50000"/>
            <a:lumOff val="50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lt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7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65000"/>
            <a:lumOff val="35000"/>
            <a:alpha val="7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65000"/>
            <a:lumOff val="35000"/>
            <a:alpha val="2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leaderLine>
  <cs:legend>
    <cs:lnRef idx="0"/>
    <cs:fillRef idx="0"/>
    <cs:effectRef idx="0"/>
    <cs:fontRef idx="minor">
      <a:schemeClr val="lt1">
        <a:lumMod val="75000"/>
      </a:schemeClr>
    </cs:fontRef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lt1">
        <a:lumMod val="7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seriesLine>
  <cs:title>
    <cs:lnRef idx="0"/>
    <cs:fillRef idx="0"/>
    <cs:effectRef idx="0"/>
    <cs:fontRef idx="minor">
      <a:schemeClr val="lt1">
        <a:lumMod val="85000"/>
      </a:schemeClr>
    </cs:fontRef>
    <cs:defRPr sz="1400" b="1" kern="1200" cap="none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25400" cap="rnd">
        <a:solidFill>
          <a:schemeClr val="phClr">
            <a:alpha val="50000"/>
          </a:schemeClr>
        </a:solidFill>
      </a:ln>
    </cs:spPr>
  </cs:trendline>
  <cs:trendlineLabel>
    <cs:lnRef idx="0"/>
    <cs:fillRef idx="0"/>
    <cs:effectRef idx="0"/>
    <cs:fontRef idx="minor">
      <a:schemeClr val="lt1">
        <a:lumMod val="7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>
          <a:lumMod val="85000"/>
        </a:schemeClr>
      </a:solidFill>
      <a:ln w="9525">
        <a:solidFill>
          <a:schemeClr val="dk1">
            <a:lumMod val="50000"/>
          </a:schemeClr>
        </a:solidFill>
        <a:round/>
      </a:ln>
    </cs:spPr>
  </cs:upBar>
  <cs:value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  <a:round/>
      </a:ln>
    </cs:spPr>
    <cs:defRPr sz="900" kern="1200"/>
    <cs:bodyPr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45">
  <cs:axisTitle>
    <cs:lnRef idx="0"/>
    <cs:fillRef idx="0"/>
    <cs:effectRef idx="0"/>
    <cs:fontRef idx="minor">
      <a:schemeClr val="lt1">
        <a:lumMod val="75000"/>
      </a:schemeClr>
    </cs:fontRef>
    <cs:defRPr sz="900" b="1" kern="1200"/>
  </cs:axisTitle>
  <cs:categoryAxis>
    <cs:lnRef idx="0"/>
    <cs:fillRef idx="0"/>
    <cs:effectRef idx="0"/>
    <cs:fontRef idx="minor">
      <a:schemeClr val="lt1">
        <a:lumMod val="75000"/>
      </a:schemeClr>
    </cs:fontRef>
    <cs:defRPr sz="900" kern="1200"/>
  </cs:categoryAxis>
  <cs:chartArea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>
        <a:lumMod val="75000"/>
      </a:schemeClr>
    </cs:fontRef>
    <cs:defRPr sz="900" kern="1200"/>
  </cs:dataLabel>
  <cs:dataLabelCallout>
    <cs:lnRef idx="0"/>
    <cs:fillRef idx="0"/>
    <cs:effectRef idx="0"/>
    <cs:fontRef idx="minor">
      <a:schemeClr val="lt1">
        <a:lumMod val="15000"/>
        <a:lumOff val="85000"/>
      </a:schemeClr>
    </cs:fontRef>
    <cs:spPr>
      <a:solidFill>
        <a:schemeClr val="dk1">
          <a:lumMod val="65000"/>
          <a:lumOff val="3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/>
    <cs:effectRef idx="0">
      <cs:styleClr val="auto"/>
    </cs:effectRef>
    <cs:fontRef idx="minor">
      <a:schemeClr val="dk1"/>
    </cs:fontRef>
    <cs:spPr>
      <a:ln w="9525" cap="flat" cmpd="sng" algn="ctr">
        <a:solidFill>
          <a:schemeClr val="phClr"/>
        </a:solidFill>
        <a:miter lim="800000"/>
      </a:ln>
      <a:effectLst>
        <a:glow rad="63500">
          <a:schemeClr val="phClr">
            <a:satMod val="175000"/>
            <a:alpha val="25000"/>
          </a:schemeClr>
        </a:glow>
      </a:effectLst>
    </cs:spPr>
  </cs:dataPoint>
  <cs:dataPoint3D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ln w="9525" cap="flat" cmpd="sng" algn="ctr">
        <a:solidFill>
          <a:schemeClr val="phClr"/>
        </a:solidFill>
        <a:miter lim="800000"/>
      </a:ln>
      <a:effectLst>
        <a:glow rad="63500">
          <a:schemeClr val="phClr">
            <a:satMod val="175000"/>
            <a:alpha val="25000"/>
          </a:schemeClr>
        </a:glow>
      </a:effectLst>
    </cs:spPr>
  </cs:dataPoint3D>
  <cs:dataPointLine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ln w="22225" cap="rnd">
        <a:solidFill>
          <a:schemeClr val="phClr"/>
        </a:solidFill>
      </a:ln>
      <a:effectLst>
        <a:glow rad="139700">
          <a:schemeClr val="phClr">
            <a:satMod val="175000"/>
            <a:alpha val="14000"/>
          </a:schemeClr>
        </a:glow>
      </a:effectLst>
    </cs:spPr>
  </cs:dataPointLine>
  <cs:dataPointMarker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solidFill>
        <a:schemeClr val="phClr">
          <a:lumMod val="60000"/>
          <a:lumOff val="40000"/>
        </a:schemeClr>
      </a:solidFill>
      <a:effectLst>
        <a:glow rad="63500">
          <a:schemeClr val="phClr">
            <a:satMod val="175000"/>
            <a:alpha val="25000"/>
          </a:schemeClr>
        </a:glow>
      </a:effectLst>
    </cs:spPr>
  </cs:dataPointMarker>
  <cs:dataPointMarkerLayout symbol="circle" size="3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lt1">
        <a:lumMod val="75000"/>
      </a:schemeClr>
    </cs:fontRef>
    <cs:spPr>
      <a:ln w="9525">
        <a:solidFill>
          <a:schemeClr val="dk1">
            <a:lumMod val="50000"/>
            <a:lumOff val="50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lt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7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65000"/>
            <a:lumOff val="35000"/>
            <a:alpha val="7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65000"/>
            <a:lumOff val="35000"/>
            <a:alpha val="2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leaderLine>
  <cs:legend>
    <cs:lnRef idx="0"/>
    <cs:fillRef idx="0"/>
    <cs:effectRef idx="0"/>
    <cs:fontRef idx="minor">
      <a:schemeClr val="lt1">
        <a:lumMod val="75000"/>
      </a:schemeClr>
    </cs:fontRef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lt1">
        <a:lumMod val="7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seriesLine>
  <cs:title>
    <cs:lnRef idx="0"/>
    <cs:fillRef idx="0"/>
    <cs:effectRef idx="0"/>
    <cs:fontRef idx="minor">
      <a:schemeClr val="lt1">
        <a:lumMod val="85000"/>
      </a:schemeClr>
    </cs:fontRef>
    <cs:defRPr sz="1400" b="1" kern="1200" cap="none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25400" cap="rnd">
        <a:solidFill>
          <a:schemeClr val="phClr">
            <a:alpha val="50000"/>
          </a:schemeClr>
        </a:solidFill>
      </a:ln>
    </cs:spPr>
  </cs:trendline>
  <cs:trendlineLabel>
    <cs:lnRef idx="0"/>
    <cs:fillRef idx="0"/>
    <cs:effectRef idx="0"/>
    <cs:fontRef idx="minor">
      <a:schemeClr val="lt1">
        <a:lumMod val="7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>
          <a:lumMod val="85000"/>
        </a:schemeClr>
      </a:solidFill>
      <a:ln w="9525">
        <a:solidFill>
          <a:schemeClr val="dk1">
            <a:lumMod val="50000"/>
          </a:schemeClr>
        </a:solidFill>
        <a:round/>
      </a:ln>
    </cs:spPr>
  </cs:upBar>
  <cs:value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  <a:round/>
      </a:ln>
    </cs:spPr>
    <cs:defRPr sz="900" kern="1200"/>
    <cs:bodyPr/>
  </cs:valueAxis>
  <cs:wall>
    <cs:lnRef idx="0"/>
    <cs:fillRef idx="0"/>
    <cs:effectRef idx="0"/>
    <cs:fontRef idx="minor">
      <a:schemeClr val="dk1"/>
    </cs:fontRef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4.emf"/><Relationship Id="rId2" Type="http://schemas.openxmlformats.org/officeDocument/2006/relationships/image" Target="../media/image63.emf"/><Relationship Id="rId1" Type="http://schemas.openxmlformats.org/officeDocument/2006/relationships/image" Target="../media/image62.emf"/><Relationship Id="rId4" Type="http://schemas.openxmlformats.org/officeDocument/2006/relationships/image" Target="../media/image6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5912D-C72D-3BEF-5AB2-E4E74D8FBD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DA45350-9998-EC83-8E97-E6FBB0EEFB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E7F77E-7C67-E594-A8BE-17BA0A060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CE3C25-8D0A-ED47-0E35-4864C3473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B7B4C-43F5-7D12-0617-D92DF130E0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09738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8BAFE2-0C02-18CC-D871-AB2ED63B16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EDE3DF-F01E-3897-24FC-3BB8D96D5D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DFB6CC-DE02-96B6-FBC5-0C3F3A49C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06A268-08CE-5AD8-BCBD-2E76FDF0B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9619C8-549E-F0E6-959B-72EE2D529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2272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29AC70-E1AA-3F62-DDEF-63302B5559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CA8E79-EFED-110F-C3C8-8A63FC3F27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53B60-7E46-03D4-4945-31A4CF45D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BAEB56-9110-FF8B-B082-8873B1DDC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944BAA-4044-9E5B-F2C6-5BA173D91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5354024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4"/>
            <a:ext cx="10363200" cy="2387600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01827754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81855176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40"/>
            <a:ext cx="10515600" cy="2852737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5"/>
            <a:ext cx="10515600" cy="150018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50410805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57067242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62943288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59409751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66830545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754111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87800B-058F-DFBA-DF83-02CACEFEDB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1DAE7A-6AA0-2B02-1F4E-6E27BC3B0A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EB9DC-6553-7273-BAE9-3B3AA1961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02B360-264C-99DA-A036-8CDDE9690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6C30F-D772-AD5A-0578-CCF494DB6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446096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35433843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42927904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402963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A97715-F5F1-8122-9D4E-5782C3FC56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DC4A47-E38C-D7BD-DD03-367A6E7779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EAFB2A-B042-54B9-2418-218598ED0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7EF175-E7DB-CE93-9705-AA8630776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749532-E226-0533-516A-98B40036A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2451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429C38-E47E-2AAE-8017-B2C38FCBD0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3B4FD4-0700-EE11-E591-646D689A88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334BA6-3A42-6D71-A39C-B27709F6C4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067CC6-D0AB-0597-0BD7-2CAC2F5C7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4F9B7B-DCF1-B1FF-8EAA-8DA006971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3F7ADD-602D-4FAA-6AA7-1A03D6D3B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96634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08D5FC-6571-3EDC-90EA-592D163F59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E8DAFD-5876-6C5C-82E2-ABAA819A89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8F1F80-D2EC-560E-BFC5-2B2A77317C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CC03F6-8DE6-4998-634E-3862098757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45E153-FC01-DFDE-45AE-E889FC5318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C04C6B-1B2F-D97C-FB31-B94E2948B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76D93A3-7345-A92D-4A75-CDD804DDB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E718AA-C82E-B53D-F23B-35BA08287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95990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E145F-3C4D-CB8D-3274-F83466F0D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119F58-73AC-941E-7AB2-60F826FBE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2176F7-D971-F428-BB05-C98FE6D33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FD4825-0DF6-F244-30D7-A0865EA20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26125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03571B-4C96-E5E9-4501-6BF5E8DEA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4D04C5-819D-7E8F-0AB9-BDCAA06A71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C11E5B-E7A3-B391-4E58-3391BE590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5159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14A06-D64C-F706-2387-0F875FAD46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BC8FC6-BC3E-C8E5-63FF-12DB1FB993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908B28-DE03-18E9-0794-EE8C66E118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A9BA90-3E2D-8A2F-95A9-A75603E3D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B5A9E1-9244-D50A-C5FD-05BB27B0B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C9ADF9-11FA-3CB8-DF0F-0E208B864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04859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4AE8DC-43C2-8EA2-5ACB-06A1E33E63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1ABC509-379E-6B0A-1E6B-B45CBF9E6B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093FE1-8005-8D3C-263A-B038397B48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4D27E7-34F5-F5C3-83A2-D84158BDD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DA4B55-BC4D-6319-B47A-0A138B7DF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3EA5F2-92F1-11AE-A58B-C44D7767F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56516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0D21EF-A390-A92C-1C36-F07CC8296C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402B07-866C-1B76-C58D-34971FE7BE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4AB89-8AF3-AC67-B0CE-10F7B11208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B7BD7-7351-4C18-B293-F4A23FCB722D}" type="datetimeFigureOut">
              <a:rPr lang="en-IN" smtClean="0"/>
              <a:t>27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63F2DC-CBB6-170D-D82B-AA77B89CBD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91B215-AB0F-148B-9FCB-421F646C07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21017-710A-47DA-A497-5A739587450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26573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97A7C-27F2-49CB-AFF1-B4F91644ECEA}" type="datetimeFigureOut">
              <a:rPr lang="en-IN" smtClean="0"/>
              <a:t>27-04-2024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F04D8-B06C-4275-B225-1A4019E2D5CF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152985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22.png"/><Relationship Id="rId26" Type="http://schemas.openxmlformats.org/officeDocument/2006/relationships/image" Target="../media/image30.png"/><Relationship Id="rId3" Type="http://schemas.openxmlformats.org/officeDocument/2006/relationships/image" Target="../media/image7.png"/><Relationship Id="rId21" Type="http://schemas.openxmlformats.org/officeDocument/2006/relationships/image" Target="../media/image25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image" Target="../media/image21.png"/><Relationship Id="rId25" Type="http://schemas.openxmlformats.org/officeDocument/2006/relationships/image" Target="../media/image29.png"/><Relationship Id="rId2" Type="http://schemas.openxmlformats.org/officeDocument/2006/relationships/image" Target="../media/image6.png"/><Relationship Id="rId16" Type="http://schemas.openxmlformats.org/officeDocument/2006/relationships/image" Target="../media/image20.png"/><Relationship Id="rId20" Type="http://schemas.openxmlformats.org/officeDocument/2006/relationships/image" Target="../media/image24.png"/><Relationship Id="rId29" Type="http://schemas.openxmlformats.org/officeDocument/2006/relationships/image" Target="../media/image33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24" Type="http://schemas.openxmlformats.org/officeDocument/2006/relationships/image" Target="../media/image28.png"/><Relationship Id="rId5" Type="http://schemas.openxmlformats.org/officeDocument/2006/relationships/image" Target="../media/image9.png"/><Relationship Id="rId15" Type="http://schemas.openxmlformats.org/officeDocument/2006/relationships/image" Target="../media/image19.png"/><Relationship Id="rId23" Type="http://schemas.openxmlformats.org/officeDocument/2006/relationships/image" Target="../media/image27.png"/><Relationship Id="rId28" Type="http://schemas.openxmlformats.org/officeDocument/2006/relationships/image" Target="../media/image32.png"/><Relationship Id="rId10" Type="http://schemas.openxmlformats.org/officeDocument/2006/relationships/image" Target="../media/image14.png"/><Relationship Id="rId19" Type="http://schemas.openxmlformats.org/officeDocument/2006/relationships/image" Target="../media/image23.png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Relationship Id="rId22" Type="http://schemas.openxmlformats.org/officeDocument/2006/relationships/image" Target="../media/image26.png"/><Relationship Id="rId27" Type="http://schemas.openxmlformats.org/officeDocument/2006/relationships/image" Target="../media/image3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openxmlformats.org/officeDocument/2006/relationships/image" Target="../media/image45.png"/><Relationship Id="rId18" Type="http://schemas.openxmlformats.org/officeDocument/2006/relationships/image" Target="../media/image50.png"/><Relationship Id="rId26" Type="http://schemas.openxmlformats.org/officeDocument/2006/relationships/image" Target="../media/image58.png"/><Relationship Id="rId3" Type="http://schemas.openxmlformats.org/officeDocument/2006/relationships/image" Target="../media/image35.png"/><Relationship Id="rId21" Type="http://schemas.openxmlformats.org/officeDocument/2006/relationships/image" Target="../media/image53.png"/><Relationship Id="rId7" Type="http://schemas.openxmlformats.org/officeDocument/2006/relationships/image" Target="../media/image39.png"/><Relationship Id="rId12" Type="http://schemas.openxmlformats.org/officeDocument/2006/relationships/image" Target="../media/image44.png"/><Relationship Id="rId17" Type="http://schemas.openxmlformats.org/officeDocument/2006/relationships/image" Target="../media/image49.png"/><Relationship Id="rId25" Type="http://schemas.openxmlformats.org/officeDocument/2006/relationships/image" Target="../media/image57.png"/><Relationship Id="rId2" Type="http://schemas.openxmlformats.org/officeDocument/2006/relationships/image" Target="../media/image34.png"/><Relationship Id="rId16" Type="http://schemas.openxmlformats.org/officeDocument/2006/relationships/image" Target="../media/image48.png"/><Relationship Id="rId20" Type="http://schemas.openxmlformats.org/officeDocument/2006/relationships/image" Target="../media/image52.png"/><Relationship Id="rId29" Type="http://schemas.openxmlformats.org/officeDocument/2006/relationships/image" Target="../media/image61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38.png"/><Relationship Id="rId11" Type="http://schemas.openxmlformats.org/officeDocument/2006/relationships/image" Target="../media/image43.png"/><Relationship Id="rId24" Type="http://schemas.openxmlformats.org/officeDocument/2006/relationships/image" Target="../media/image56.png"/><Relationship Id="rId5" Type="http://schemas.openxmlformats.org/officeDocument/2006/relationships/image" Target="../media/image37.png"/><Relationship Id="rId15" Type="http://schemas.openxmlformats.org/officeDocument/2006/relationships/image" Target="../media/image47.png"/><Relationship Id="rId23" Type="http://schemas.openxmlformats.org/officeDocument/2006/relationships/image" Target="../media/image55.png"/><Relationship Id="rId28" Type="http://schemas.openxmlformats.org/officeDocument/2006/relationships/image" Target="../media/image60.png"/><Relationship Id="rId10" Type="http://schemas.openxmlformats.org/officeDocument/2006/relationships/image" Target="../media/image42.png"/><Relationship Id="rId19" Type="http://schemas.openxmlformats.org/officeDocument/2006/relationships/image" Target="../media/image51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Relationship Id="rId14" Type="http://schemas.openxmlformats.org/officeDocument/2006/relationships/image" Target="../media/image46.png"/><Relationship Id="rId22" Type="http://schemas.openxmlformats.org/officeDocument/2006/relationships/image" Target="../media/image54.png"/><Relationship Id="rId27" Type="http://schemas.openxmlformats.org/officeDocument/2006/relationships/image" Target="../media/image5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3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65.emf"/><Relationship Id="rId4" Type="http://schemas.openxmlformats.org/officeDocument/2006/relationships/image" Target="../media/image62.emf"/><Relationship Id="rId9" Type="http://schemas.openxmlformats.org/officeDocument/2006/relationships/oleObject" Target="../embeddings/oleObject4.bin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92A2BAE-36C2-2323-BEFF-4C5CD9DB3E88}"/>
              </a:ext>
            </a:extLst>
          </p:cNvPr>
          <p:cNvGrpSpPr/>
          <p:nvPr/>
        </p:nvGrpSpPr>
        <p:grpSpPr>
          <a:xfrm>
            <a:off x="633212" y="2581000"/>
            <a:ext cx="5295562" cy="1944926"/>
            <a:chOff x="1228080" y="2090873"/>
            <a:chExt cx="9239026" cy="1975511"/>
          </a:xfrm>
        </p:grpSpPr>
        <p:pic>
          <p:nvPicPr>
            <p:cNvPr id="5" name="Picture 2" descr="F:\ChemiDoc Images 2021-06-04_18.48.09\chemidoc 2021-06-04 18h13m54s(Ethidium Bromide).jpg">
              <a:extLst>
                <a:ext uri="{FF2B5EF4-FFF2-40B4-BE49-F238E27FC236}">
                  <a16:creationId xmlns:a16="http://schemas.microsoft.com/office/drawing/2014/main" id="{FEF63110-8110-A6E3-A32D-364CD1F5B1B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-25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34760" t="17860" r="49818" b="22597"/>
            <a:stretch>
              <a:fillRect/>
            </a:stretch>
          </p:blipFill>
          <p:spPr bwMode="auto">
            <a:xfrm flipH="1">
              <a:off x="8217976" y="2325244"/>
              <a:ext cx="1266840" cy="174114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5A2A181-FBD3-FD99-DDB2-FFE8FF077292}"/>
                </a:ext>
              </a:extLst>
            </p:cNvPr>
            <p:cNvSpPr txBox="1"/>
            <p:nvPr/>
          </p:nvSpPr>
          <p:spPr>
            <a:xfrm>
              <a:off x="1536402" y="2106832"/>
              <a:ext cx="2049143" cy="3438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     1    2     3      4      5      6</a:t>
              </a: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507542B5-67E3-83D3-3A33-64B8FE225839}"/>
                </a:ext>
              </a:extLst>
            </p:cNvPr>
            <p:cNvCxnSpPr>
              <a:cxnSpLocks/>
            </p:cNvCxnSpPr>
            <p:nvPr/>
          </p:nvCxnSpPr>
          <p:spPr>
            <a:xfrm>
              <a:off x="9340800" y="2926635"/>
              <a:ext cx="28803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07F3E168-4AC8-FEB5-EC11-5882C4203490}"/>
                </a:ext>
              </a:extLst>
            </p:cNvPr>
            <p:cNvCxnSpPr>
              <a:cxnSpLocks/>
            </p:cNvCxnSpPr>
            <p:nvPr/>
          </p:nvCxnSpPr>
          <p:spPr>
            <a:xfrm>
              <a:off x="9340800" y="3141348"/>
              <a:ext cx="29961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0E576C3-5D3F-E3E1-0159-96467EE4D344}"/>
                </a:ext>
              </a:extLst>
            </p:cNvPr>
            <p:cNvSpPr txBox="1"/>
            <p:nvPr/>
          </p:nvSpPr>
          <p:spPr>
            <a:xfrm>
              <a:off x="1228080" y="2926635"/>
              <a:ext cx="458129" cy="8440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  <a:p>
              <a:pPr algn="ctr"/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10" name="Plus 21">
              <a:extLst>
                <a:ext uri="{FF2B5EF4-FFF2-40B4-BE49-F238E27FC236}">
                  <a16:creationId xmlns:a16="http://schemas.microsoft.com/office/drawing/2014/main" id="{2BD84AF4-CD55-A9D8-D36B-33015DD65707}"/>
                </a:ext>
              </a:extLst>
            </p:cNvPr>
            <p:cNvSpPr/>
            <p:nvPr/>
          </p:nvSpPr>
          <p:spPr>
            <a:xfrm>
              <a:off x="4540032" y="3030489"/>
              <a:ext cx="293887" cy="288032"/>
            </a:xfrm>
            <a:prstGeom prst="mathPlus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B74F483-E392-514D-C1FF-84E920F9F7F9}"/>
                </a:ext>
              </a:extLst>
            </p:cNvPr>
            <p:cNvSpPr txBox="1"/>
            <p:nvPr/>
          </p:nvSpPr>
          <p:spPr>
            <a:xfrm>
              <a:off x="4250425" y="3462539"/>
              <a:ext cx="1008112" cy="3438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igation</a:t>
              </a: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37047EDF-DF82-E054-B6D0-A0EB8DDC8E32}"/>
                </a:ext>
              </a:extLst>
            </p:cNvPr>
            <p:cNvCxnSpPr>
              <a:cxnSpLocks/>
            </p:cNvCxnSpPr>
            <p:nvPr/>
          </p:nvCxnSpPr>
          <p:spPr>
            <a:xfrm>
              <a:off x="7202753" y="3318522"/>
              <a:ext cx="504000" cy="0"/>
            </a:xfrm>
            <a:prstGeom prst="straightConnector1">
              <a:avLst/>
            </a:prstGeom>
            <a:ln w="34925" cmpd="sng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" name="Picture 3">
              <a:extLst>
                <a:ext uri="{FF2B5EF4-FFF2-40B4-BE49-F238E27FC236}">
                  <a16:creationId xmlns:a16="http://schemas.microsoft.com/office/drawing/2014/main" id="{F01F5DE0-03E4-D221-1A8D-202CA6D68E0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662639" y="2325244"/>
              <a:ext cx="1817665" cy="1639608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EEF360D9-0613-F61C-4090-BF855D7861C8}"/>
                </a:ext>
              </a:extLst>
            </p:cNvPr>
            <p:cNvCxnSpPr>
              <a:cxnSpLocks/>
              <a:stCxn id="13" idx="3"/>
            </p:cNvCxnSpPr>
            <p:nvPr/>
          </p:nvCxnSpPr>
          <p:spPr>
            <a:xfrm flipH="1">
              <a:off x="3175224" y="3145048"/>
              <a:ext cx="30508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9D096AC-2A5E-0A4D-D6A0-4A8641A66BF9}"/>
                </a:ext>
              </a:extLst>
            </p:cNvPr>
            <p:cNvSpPr txBox="1"/>
            <p:nvPr/>
          </p:nvSpPr>
          <p:spPr>
            <a:xfrm>
              <a:off x="3338475" y="2993555"/>
              <a:ext cx="966354" cy="593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~250 bp Small Protein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8FC9D30-8C07-C9F1-2E1F-1BA330D94146}"/>
                </a:ext>
              </a:extLst>
            </p:cNvPr>
            <p:cNvSpPr txBox="1"/>
            <p:nvPr/>
          </p:nvSpPr>
          <p:spPr>
            <a:xfrm>
              <a:off x="8070427" y="2090873"/>
              <a:ext cx="1414389" cy="3438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 1         2          M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ACE50D84-E478-FEC9-0B5C-5E88B386C0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0500"/>
            <a:stretch/>
          </p:blipFill>
          <p:spPr>
            <a:xfrm>
              <a:off x="5079148" y="2325243"/>
              <a:ext cx="2069441" cy="1639603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032611F-C9A5-6C3F-2CB7-3248C4D8A842}"/>
                </a:ext>
              </a:extLst>
            </p:cNvPr>
            <p:cNvSpPr txBox="1"/>
            <p:nvPr/>
          </p:nvSpPr>
          <p:spPr>
            <a:xfrm>
              <a:off x="9628829" y="2823434"/>
              <a:ext cx="838277" cy="4689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</a:p>
            <a:p>
              <a:pPr algn="ctr"/>
              <a:endParaRPr lang="en-I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0.2 kb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A0DB2C82-566B-B861-63EF-1347C8D69965}"/>
                </a:ext>
              </a:extLst>
            </p:cNvPr>
            <p:cNvCxnSpPr>
              <a:cxnSpLocks/>
            </p:cNvCxnSpPr>
            <p:nvPr/>
          </p:nvCxnSpPr>
          <p:spPr>
            <a:xfrm>
              <a:off x="1547986" y="3014564"/>
              <a:ext cx="28803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58300D25-BFAB-C221-805B-17E36210557C}"/>
                </a:ext>
              </a:extLst>
            </p:cNvPr>
            <p:cNvCxnSpPr>
              <a:cxnSpLocks/>
            </p:cNvCxnSpPr>
            <p:nvPr/>
          </p:nvCxnSpPr>
          <p:spPr>
            <a:xfrm>
              <a:off x="1536402" y="3168113"/>
              <a:ext cx="29961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551AE228-402A-DC72-981C-B9AB72FC4FA7}"/>
              </a:ext>
            </a:extLst>
          </p:cNvPr>
          <p:cNvGrpSpPr/>
          <p:nvPr/>
        </p:nvGrpSpPr>
        <p:grpSpPr>
          <a:xfrm>
            <a:off x="6098511" y="1623748"/>
            <a:ext cx="5676319" cy="3304522"/>
            <a:chOff x="3292723" y="2054411"/>
            <a:chExt cx="6742006" cy="2242381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4ED0453-1842-253E-E32F-7BDA2758D28E}"/>
                </a:ext>
              </a:extLst>
            </p:cNvPr>
            <p:cNvSpPr txBox="1"/>
            <p:nvPr/>
          </p:nvSpPr>
          <p:spPr>
            <a:xfrm>
              <a:off x="9325859" y="3844981"/>
              <a:ext cx="708870" cy="31327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I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mall Protein</a:t>
              </a:r>
            </a:p>
            <a:p>
              <a:pPr algn="ctr"/>
              <a:endParaRPr lang="en-I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A0A267B1-D655-101A-D2A1-E1F69829CC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33000"/>
                      </a14:imgEffect>
                    </a14:imgLayer>
                  </a14:imgProps>
                </a:ext>
              </a:extLst>
            </a:blip>
            <a:srcRect l="2987" t="20296" r="54965" b="14795"/>
            <a:stretch/>
          </p:blipFill>
          <p:spPr>
            <a:xfrm>
              <a:off x="3292723" y="2771567"/>
              <a:ext cx="2597552" cy="1525225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9B7E5A18-8615-2288-8DB9-AF0B473CA5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66000"/>
                      </a14:imgEffect>
                    </a14:imgLayer>
                  </a14:imgProps>
                </a:ext>
              </a:extLst>
            </a:blip>
            <a:srcRect l="57591" t="24812" r="4824" b="26655"/>
            <a:stretch/>
          </p:blipFill>
          <p:spPr>
            <a:xfrm>
              <a:off x="6570123" y="2818323"/>
              <a:ext cx="2597552" cy="1385901"/>
            </a:xfrm>
            <a:prstGeom prst="rect">
              <a:avLst/>
            </a:prstGeom>
            <a:ln>
              <a:noFill/>
            </a:ln>
            <a:effectLst>
              <a:outerShdw blurRad="292100" dist="139700" dir="2700000" algn="tl" rotWithShape="0">
                <a:srgbClr val="333333">
                  <a:alpha val="65000"/>
                </a:srgbClr>
              </a:outerShdw>
            </a:effectLst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CC56AB4-BAE3-E8DB-2ACC-08A50EA8A8C9}"/>
                </a:ext>
              </a:extLst>
            </p:cNvPr>
            <p:cNvSpPr txBox="1"/>
            <p:nvPr/>
          </p:nvSpPr>
          <p:spPr>
            <a:xfrm rot="16200000">
              <a:off x="2994467" y="2366583"/>
              <a:ext cx="880235" cy="25589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acterial Lysate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101CEFA-4E87-1B4E-4E0D-8A8085BE7731}"/>
                </a:ext>
              </a:extLst>
            </p:cNvPr>
            <p:cNvSpPr txBox="1"/>
            <p:nvPr/>
          </p:nvSpPr>
          <p:spPr>
            <a:xfrm rot="16200000">
              <a:off x="3376174" y="2423721"/>
              <a:ext cx="765959" cy="25589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nInduced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B34A9BD-6DE1-6BAA-0867-A5E6CABDC213}"/>
                </a:ext>
              </a:extLst>
            </p:cNvPr>
            <p:cNvSpPr txBox="1"/>
            <p:nvPr/>
          </p:nvSpPr>
          <p:spPr>
            <a:xfrm rot="16200000">
              <a:off x="3572159" y="2412723"/>
              <a:ext cx="743957" cy="25589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nduced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7A4438C-F21B-73AF-87DE-A35E1EFAEE12}"/>
                </a:ext>
              </a:extLst>
            </p:cNvPr>
            <p:cNvSpPr txBox="1"/>
            <p:nvPr/>
          </p:nvSpPr>
          <p:spPr>
            <a:xfrm rot="16200000">
              <a:off x="3852354" y="2412724"/>
              <a:ext cx="743956" cy="25589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nduced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94CDBEF-C8DC-715E-5D7B-B3AE52DB38C0}"/>
                </a:ext>
              </a:extLst>
            </p:cNvPr>
            <p:cNvSpPr txBox="1"/>
            <p:nvPr/>
          </p:nvSpPr>
          <p:spPr>
            <a:xfrm>
              <a:off x="4530919" y="2520328"/>
              <a:ext cx="1220711" cy="14619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T  W1   W2     M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AE1F3F1-BFCE-910D-D142-88551DCAC3C6}"/>
                </a:ext>
              </a:extLst>
            </p:cNvPr>
            <p:cNvSpPr txBox="1"/>
            <p:nvPr/>
          </p:nvSpPr>
          <p:spPr>
            <a:xfrm>
              <a:off x="6476201" y="2524155"/>
              <a:ext cx="2597553" cy="14619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     W3     W4           E1    E2    E3    E4     </a:t>
              </a:r>
            </a:p>
          </p:txBody>
        </p:sp>
        <p:cxnSp>
          <p:nvCxnSpPr>
            <p:cNvPr id="31" name="AutoShape 3">
              <a:extLst>
                <a:ext uri="{FF2B5EF4-FFF2-40B4-BE49-F238E27FC236}">
                  <a16:creationId xmlns:a16="http://schemas.microsoft.com/office/drawing/2014/main" id="{EE5B0397-0AC8-7B4E-CC51-ABA0D403477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8686742" y="4000206"/>
              <a:ext cx="720078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965F307-4659-06AA-B90D-DCB46C2BA974}"/>
                </a:ext>
              </a:extLst>
            </p:cNvPr>
            <p:cNvSpPr txBox="1"/>
            <p:nvPr/>
          </p:nvSpPr>
          <p:spPr>
            <a:xfrm>
              <a:off x="6074322" y="3203701"/>
              <a:ext cx="596420" cy="73097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5kDa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5kDa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5kDa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5kDa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5kDa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0kDa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kDa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B901D900-BD4B-F2C6-F62E-C2826CFB5B14}"/>
              </a:ext>
            </a:extLst>
          </p:cNvPr>
          <p:cNvSpPr txBox="1"/>
          <p:nvPr/>
        </p:nvSpPr>
        <p:spPr>
          <a:xfrm>
            <a:off x="633212" y="677333"/>
            <a:ext cx="922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 Fig: 1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DDEEAAF-6298-7665-D1B3-676FCCD656A1}"/>
              </a:ext>
            </a:extLst>
          </p:cNvPr>
          <p:cNvSpPr txBox="1"/>
          <p:nvPr/>
        </p:nvSpPr>
        <p:spPr>
          <a:xfrm>
            <a:off x="981667" y="1792154"/>
            <a:ext cx="4265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72F9243-F75A-6C90-BD3C-F8C7A1928F7B}"/>
              </a:ext>
            </a:extLst>
          </p:cNvPr>
          <p:cNvSpPr txBox="1"/>
          <p:nvPr/>
        </p:nvSpPr>
        <p:spPr>
          <a:xfrm>
            <a:off x="5612946" y="1851420"/>
            <a:ext cx="500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51838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8DAD4BD9-A4E6-49EC-9E71-4EEB38ADC5A4}"/>
              </a:ext>
            </a:extLst>
          </p:cNvPr>
          <p:cNvGrpSpPr/>
          <p:nvPr/>
        </p:nvGrpSpPr>
        <p:grpSpPr>
          <a:xfrm>
            <a:off x="3558590" y="1631347"/>
            <a:ext cx="5073347" cy="3020193"/>
            <a:chOff x="2398013" y="1754615"/>
            <a:chExt cx="7219029" cy="2889472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8EC63C1-C27A-46D5-9A15-A7C3012324B1}"/>
                </a:ext>
              </a:extLst>
            </p:cNvPr>
            <p:cNvGrpSpPr/>
            <p:nvPr/>
          </p:nvGrpSpPr>
          <p:grpSpPr>
            <a:xfrm>
              <a:off x="2398013" y="1754615"/>
              <a:ext cx="7219029" cy="2889472"/>
              <a:chOff x="3177959" y="1754615"/>
              <a:chExt cx="7219029" cy="2889472"/>
            </a:xfrm>
          </p:grpSpPr>
          <p:graphicFrame>
            <p:nvGraphicFramePr>
              <p:cNvPr id="4" name="Chart 3">
                <a:extLst>
                  <a:ext uri="{FF2B5EF4-FFF2-40B4-BE49-F238E27FC236}">
                    <a16:creationId xmlns:a16="http://schemas.microsoft.com/office/drawing/2014/main" id="{A99444F1-A87B-43C6-B277-CC48B7A9D5BD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3739568" y="1754615"/>
              <a:ext cx="2607000" cy="167438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5" name="Chart 4">
                <a:extLst>
                  <a:ext uri="{FF2B5EF4-FFF2-40B4-BE49-F238E27FC236}">
                    <a16:creationId xmlns:a16="http://schemas.microsoft.com/office/drawing/2014/main" id="{4B375CB0-9B42-47B7-BD19-C8F2C27C81B8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7789987" y="1754615"/>
              <a:ext cx="2607001" cy="167438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4AD5E29A-AD22-452E-A507-E71AC258B712}"/>
                  </a:ext>
                </a:extLst>
              </p:cNvPr>
              <p:cNvSpPr txBox="1"/>
              <p:nvPr/>
            </p:nvSpPr>
            <p:spPr>
              <a:xfrm>
                <a:off x="4414577" y="4261295"/>
                <a:ext cx="1115283" cy="3827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2900"/>
                <a:r>
                  <a:rPr 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pitope mix 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0135D56E-C972-4114-8AFF-969245D54807}"/>
                  </a:ext>
                </a:extLst>
              </p:cNvPr>
              <p:cNvSpPr txBox="1"/>
              <p:nvPr/>
            </p:nvSpPr>
            <p:spPr>
              <a:xfrm>
                <a:off x="8770554" y="4260977"/>
                <a:ext cx="1115279" cy="3827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2900"/>
                <a:r>
                  <a:rPr 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mall protein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B0B888EA-47B9-4AB4-B9D6-B3571E77F6E9}"/>
                  </a:ext>
                </a:extLst>
              </p:cNvPr>
              <p:cNvSpPr txBox="1"/>
              <p:nvPr/>
            </p:nvSpPr>
            <p:spPr>
              <a:xfrm rot="16200000">
                <a:off x="3116238" y="2476446"/>
                <a:ext cx="692772" cy="569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2900"/>
                <a:r>
                  <a:rPr 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D 450nm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6A36DB7-2839-4EB5-ACEA-31981FEDA43E}"/>
                  </a:ext>
                </a:extLst>
              </p:cNvPr>
              <p:cNvSpPr txBox="1"/>
              <p:nvPr/>
            </p:nvSpPr>
            <p:spPr>
              <a:xfrm rot="16200000">
                <a:off x="7202241" y="2355519"/>
                <a:ext cx="724525" cy="569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2900"/>
                <a:r>
                  <a:rPr 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D 450nm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C23C08A-C0A8-43B0-ADFC-40EB0A226A38}"/>
                  </a:ext>
                </a:extLst>
              </p:cNvPr>
              <p:cNvSpPr txBox="1"/>
              <p:nvPr/>
            </p:nvSpPr>
            <p:spPr>
              <a:xfrm>
                <a:off x="4143844" y="3603105"/>
                <a:ext cx="1798448" cy="5300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2900"/>
                <a:r>
                  <a:rPr 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pitope  mix antiserum dilutions 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0909E181-0162-4B8C-BE1F-0281D5F49D0C}"/>
                  </a:ext>
                </a:extLst>
              </p:cNvPr>
              <p:cNvSpPr txBox="1"/>
              <p:nvPr/>
            </p:nvSpPr>
            <p:spPr>
              <a:xfrm>
                <a:off x="8194263" y="3602789"/>
                <a:ext cx="1798448" cy="5300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42900"/>
                <a:r>
                  <a:rPr lang="en-US" sz="10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mall protein antiserum dilutions </a:t>
                </a:r>
              </a:p>
            </p:txBody>
          </p:sp>
        </p:grp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488CAFD2-BE31-4142-85C9-81B92906054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2073" y="2406646"/>
              <a:ext cx="123612" cy="20101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03CA6C20-38E0-47C8-91EF-FE446852124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95651" y="2277920"/>
              <a:ext cx="17755" cy="25745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7E6BC4EE-2D48-4595-8222-2B3D132FA337}"/>
              </a:ext>
            </a:extLst>
          </p:cNvPr>
          <p:cNvSpPr txBox="1"/>
          <p:nvPr/>
        </p:nvSpPr>
        <p:spPr>
          <a:xfrm>
            <a:off x="798769" y="670163"/>
            <a:ext cx="98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42900"/>
            <a:r>
              <a:rPr lang="en-IN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 Fig: 2</a:t>
            </a:r>
          </a:p>
        </p:txBody>
      </p:sp>
    </p:spTree>
    <p:extLst>
      <p:ext uri="{BB962C8B-B14F-4D97-AF65-F5344CB8AC3E}">
        <p14:creationId xmlns:p14="http://schemas.microsoft.com/office/powerpoint/2010/main" val="34615566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>
            <a:extLst>
              <a:ext uri="{FF2B5EF4-FFF2-40B4-BE49-F238E27FC236}">
                <a16:creationId xmlns:a16="http://schemas.microsoft.com/office/drawing/2014/main" id="{6BCA43A8-D0F9-4D00-82DE-48082D03BF97}"/>
              </a:ext>
            </a:extLst>
          </p:cNvPr>
          <p:cNvGrpSpPr/>
          <p:nvPr/>
        </p:nvGrpSpPr>
        <p:grpSpPr>
          <a:xfrm>
            <a:off x="0" y="-8604"/>
            <a:ext cx="12149969" cy="6866603"/>
            <a:chOff x="0" y="-8604"/>
            <a:chExt cx="12149969" cy="6866603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B3912DBD-08A9-4E61-AC73-2ABB9E9DD4C2}"/>
                </a:ext>
              </a:extLst>
            </p:cNvPr>
            <p:cNvGrpSpPr/>
            <p:nvPr/>
          </p:nvGrpSpPr>
          <p:grpSpPr>
            <a:xfrm>
              <a:off x="0" y="189802"/>
              <a:ext cx="12149969" cy="6668197"/>
              <a:chOff x="-66675" y="0"/>
              <a:chExt cx="12849225" cy="6851240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5E281693-5278-4264-BD91-F984AA979854}"/>
                  </a:ext>
                </a:extLst>
              </p:cNvPr>
              <p:cNvGrpSpPr/>
              <p:nvPr/>
            </p:nvGrpSpPr>
            <p:grpSpPr>
              <a:xfrm>
                <a:off x="-66675" y="0"/>
                <a:ext cx="12849225" cy="6652892"/>
                <a:chOff x="-47625" y="102554"/>
                <a:chExt cx="12849225" cy="6652892"/>
              </a:xfrm>
            </p:grpSpPr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A77CAF06-BF72-47E8-B0A4-70101979F4BA}"/>
                    </a:ext>
                  </a:extLst>
                </p:cNvPr>
                <p:cNvGrpSpPr/>
                <p:nvPr/>
              </p:nvGrpSpPr>
              <p:grpSpPr>
                <a:xfrm>
                  <a:off x="0" y="102554"/>
                  <a:ext cx="12801600" cy="6652892"/>
                  <a:chOff x="-95250" y="0"/>
                  <a:chExt cx="12201525" cy="6447784"/>
                </a:xfrm>
              </p:grpSpPr>
              <p:grpSp>
                <p:nvGrpSpPr>
                  <p:cNvPr id="15" name="Group 14">
                    <a:extLst>
                      <a:ext uri="{FF2B5EF4-FFF2-40B4-BE49-F238E27FC236}">
                        <a16:creationId xmlns:a16="http://schemas.microsoft.com/office/drawing/2014/main" id="{DB291F67-08D7-43AC-A152-706CE4E8743F}"/>
                      </a:ext>
                    </a:extLst>
                  </p:cNvPr>
                  <p:cNvGrpSpPr/>
                  <p:nvPr/>
                </p:nvGrpSpPr>
                <p:grpSpPr>
                  <a:xfrm>
                    <a:off x="-95250" y="20287"/>
                    <a:ext cx="1661690" cy="6420041"/>
                    <a:chOff x="205773" y="-22121"/>
                    <a:chExt cx="1737588" cy="6821940"/>
                  </a:xfrm>
                </p:grpSpPr>
                <p:pic>
                  <p:nvPicPr>
                    <p:cNvPr id="46" name="Picture 45">
                      <a:extLst>
                        <a:ext uri="{FF2B5EF4-FFF2-40B4-BE49-F238E27FC236}">
                          <a16:creationId xmlns:a16="http://schemas.microsoft.com/office/drawing/2014/main" id="{0D161165-4ACB-4D88-BC3F-1207BF1BAF4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207215" y="1645926"/>
                      <a:ext cx="1736146" cy="170901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7" name="Picture 46">
                      <a:extLst>
                        <a:ext uri="{FF2B5EF4-FFF2-40B4-BE49-F238E27FC236}">
                          <a16:creationId xmlns:a16="http://schemas.microsoft.com/office/drawing/2014/main" id="{80746074-46CB-4917-9C6F-4F05AB55ABF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205776" y="-22121"/>
                      <a:ext cx="1736146" cy="170901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8" name="Picture 47">
                      <a:extLst>
                        <a:ext uri="{FF2B5EF4-FFF2-40B4-BE49-F238E27FC236}">
                          <a16:creationId xmlns:a16="http://schemas.microsoft.com/office/drawing/2014/main" id="{6EF5F361-EFDE-48DC-8762-B08C292DC11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205773" y="5090800"/>
                      <a:ext cx="1736149" cy="170901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9" name="Picture 48">
                      <a:extLst>
                        <a:ext uri="{FF2B5EF4-FFF2-40B4-BE49-F238E27FC236}">
                          <a16:creationId xmlns:a16="http://schemas.microsoft.com/office/drawing/2014/main" id="{390DD93E-9D1D-453F-A276-AFC3D3964A1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205776" y="3370539"/>
                      <a:ext cx="1736146" cy="1709019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16" name="Group 15">
                    <a:extLst>
                      <a:ext uri="{FF2B5EF4-FFF2-40B4-BE49-F238E27FC236}">
                        <a16:creationId xmlns:a16="http://schemas.microsoft.com/office/drawing/2014/main" id="{2F83F15A-2592-43E0-B908-6630DE382E2C}"/>
                      </a:ext>
                    </a:extLst>
                  </p:cNvPr>
                  <p:cNvGrpSpPr/>
                  <p:nvPr/>
                </p:nvGrpSpPr>
                <p:grpSpPr>
                  <a:xfrm>
                    <a:off x="1540340" y="20853"/>
                    <a:ext cx="1691899" cy="6426931"/>
                    <a:chOff x="19803" y="-37710"/>
                    <a:chExt cx="1769176" cy="6806815"/>
                  </a:xfrm>
                </p:grpSpPr>
                <p:pic>
                  <p:nvPicPr>
                    <p:cNvPr id="42" name="Picture 41">
                      <a:extLst>
                        <a:ext uri="{FF2B5EF4-FFF2-40B4-BE49-F238E27FC236}">
                          <a16:creationId xmlns:a16="http://schemas.microsoft.com/office/drawing/2014/main" id="{3A729661-E0DE-48C7-AF5A-8A4E14DB0BB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26731" y="1624975"/>
                      <a:ext cx="1736868" cy="170973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3" name="Picture 42">
                      <a:extLst>
                        <a:ext uri="{FF2B5EF4-FFF2-40B4-BE49-F238E27FC236}">
                          <a16:creationId xmlns:a16="http://schemas.microsoft.com/office/drawing/2014/main" id="{09E8EC9A-A935-41C3-804A-5AAA291C0D9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19803" y="3344307"/>
                      <a:ext cx="1769176" cy="170973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4" name="Picture 43">
                      <a:extLst>
                        <a:ext uri="{FF2B5EF4-FFF2-40B4-BE49-F238E27FC236}">
                          <a16:creationId xmlns:a16="http://schemas.microsoft.com/office/drawing/2014/main" id="{9A793079-131F-4B72-A89A-03DF6DFDD9E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8"/>
                    <a:stretch>
                      <a:fillRect/>
                    </a:stretch>
                  </p:blipFill>
                  <p:spPr>
                    <a:xfrm>
                      <a:off x="19804" y="-37710"/>
                      <a:ext cx="1736868" cy="170972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5" name="Picture 44">
                      <a:extLst>
                        <a:ext uri="{FF2B5EF4-FFF2-40B4-BE49-F238E27FC236}">
                          <a16:creationId xmlns:a16="http://schemas.microsoft.com/office/drawing/2014/main" id="{EC6703CB-F53D-4C0E-BF15-F0ED664FAF2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19804" y="5059376"/>
                      <a:ext cx="1736868" cy="1709729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17" name="Group 16">
                    <a:extLst>
                      <a:ext uri="{FF2B5EF4-FFF2-40B4-BE49-F238E27FC236}">
                        <a16:creationId xmlns:a16="http://schemas.microsoft.com/office/drawing/2014/main" id="{1FED5049-F4FC-470D-8902-242EB1E5C171}"/>
                      </a:ext>
                    </a:extLst>
                  </p:cNvPr>
                  <p:cNvGrpSpPr/>
                  <p:nvPr/>
                </p:nvGrpSpPr>
                <p:grpSpPr>
                  <a:xfrm>
                    <a:off x="3203343" y="0"/>
                    <a:ext cx="1691899" cy="6440328"/>
                    <a:chOff x="-1636938" y="-6409"/>
                    <a:chExt cx="1728406" cy="6967300"/>
                  </a:xfrm>
                </p:grpSpPr>
                <p:pic>
                  <p:nvPicPr>
                    <p:cNvPr id="38" name="Picture 37">
                      <a:extLst>
                        <a:ext uri="{FF2B5EF4-FFF2-40B4-BE49-F238E27FC236}">
                          <a16:creationId xmlns:a16="http://schemas.microsoft.com/office/drawing/2014/main" id="{9B2DE003-A6F0-4816-B661-08E4C9CDCF3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0"/>
                    <a:stretch>
                      <a:fillRect/>
                    </a:stretch>
                  </p:blipFill>
                  <p:spPr>
                    <a:xfrm>
                      <a:off x="-1636938" y="1705274"/>
                      <a:ext cx="1728406" cy="175724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9" name="Picture 38">
                      <a:extLst>
                        <a:ext uri="{FF2B5EF4-FFF2-40B4-BE49-F238E27FC236}">
                          <a16:creationId xmlns:a16="http://schemas.microsoft.com/office/drawing/2014/main" id="{31793F56-3AB4-4E88-886E-A716EA7F043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>
                      <a:off x="-1636938" y="-6409"/>
                      <a:ext cx="1728406" cy="177077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0" name="Picture 39">
                      <a:extLst>
                        <a:ext uri="{FF2B5EF4-FFF2-40B4-BE49-F238E27FC236}">
                          <a16:creationId xmlns:a16="http://schemas.microsoft.com/office/drawing/2014/main" id="{B7E51597-F27B-4B28-AC80-0667A4AF11A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2"/>
                    <a:stretch>
                      <a:fillRect/>
                    </a:stretch>
                  </p:blipFill>
                  <p:spPr>
                    <a:xfrm>
                      <a:off x="-1606542" y="5217192"/>
                      <a:ext cx="1698010" cy="174369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1" name="Picture 40">
                      <a:extLst>
                        <a:ext uri="{FF2B5EF4-FFF2-40B4-BE49-F238E27FC236}">
                          <a16:creationId xmlns:a16="http://schemas.microsoft.com/office/drawing/2014/main" id="{C6434A9A-0DF6-46DB-A351-78162ED0118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3"/>
                    <a:stretch>
                      <a:fillRect/>
                    </a:stretch>
                  </p:blipFill>
                  <p:spPr>
                    <a:xfrm>
                      <a:off x="-1606542" y="3432548"/>
                      <a:ext cx="1698010" cy="1796908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18" name="Group 17">
                    <a:extLst>
                      <a:ext uri="{FF2B5EF4-FFF2-40B4-BE49-F238E27FC236}">
                        <a16:creationId xmlns:a16="http://schemas.microsoft.com/office/drawing/2014/main" id="{2C286AA0-B9B1-4DC5-872C-D8F0F28F87BB}"/>
                      </a:ext>
                    </a:extLst>
                  </p:cNvPr>
                  <p:cNvGrpSpPr/>
                  <p:nvPr/>
                </p:nvGrpSpPr>
                <p:grpSpPr>
                  <a:xfrm>
                    <a:off x="4810953" y="20210"/>
                    <a:ext cx="1782717" cy="6427572"/>
                    <a:chOff x="123955" y="-25687"/>
                    <a:chExt cx="1811967" cy="6864771"/>
                  </a:xfrm>
                </p:grpSpPr>
                <p:pic>
                  <p:nvPicPr>
                    <p:cNvPr id="34" name="Picture 33">
                      <a:extLst>
                        <a:ext uri="{FF2B5EF4-FFF2-40B4-BE49-F238E27FC236}">
                          <a16:creationId xmlns:a16="http://schemas.microsoft.com/office/drawing/2014/main" id="{75896795-7F46-48D1-843C-00B9576D892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4"/>
                    <a:stretch>
                      <a:fillRect/>
                    </a:stretch>
                  </p:blipFill>
                  <p:spPr>
                    <a:xfrm>
                      <a:off x="154469" y="1648574"/>
                      <a:ext cx="1769396" cy="174174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5" name="Picture 34">
                      <a:extLst>
                        <a:ext uri="{FF2B5EF4-FFF2-40B4-BE49-F238E27FC236}">
                          <a16:creationId xmlns:a16="http://schemas.microsoft.com/office/drawing/2014/main" id="{8174E3D3-9C39-4B25-9131-D980BE96CBE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5"/>
                    <a:stretch>
                      <a:fillRect/>
                    </a:stretch>
                  </p:blipFill>
                  <p:spPr>
                    <a:xfrm>
                      <a:off x="163935" y="5097335"/>
                      <a:ext cx="1769396" cy="174174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6" name="Picture 35">
                      <a:extLst>
                        <a:ext uri="{FF2B5EF4-FFF2-40B4-BE49-F238E27FC236}">
                          <a16:creationId xmlns:a16="http://schemas.microsoft.com/office/drawing/2014/main" id="{F52E0434-B446-4CCA-A2AC-E6530E32F40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123955" y="3353751"/>
                      <a:ext cx="1811967" cy="178365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7" name="Picture 36">
                      <a:extLst>
                        <a:ext uri="{FF2B5EF4-FFF2-40B4-BE49-F238E27FC236}">
                          <a16:creationId xmlns:a16="http://schemas.microsoft.com/office/drawing/2014/main" id="{1E61B53B-AFA7-40AF-917A-DDBAE8A95B2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7"/>
                    <a:stretch>
                      <a:fillRect/>
                    </a:stretch>
                  </p:blipFill>
                  <p:spPr>
                    <a:xfrm>
                      <a:off x="172416" y="-25687"/>
                      <a:ext cx="1751226" cy="1723863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19" name="Group 18">
                    <a:extLst>
                      <a:ext uri="{FF2B5EF4-FFF2-40B4-BE49-F238E27FC236}">
                        <a16:creationId xmlns:a16="http://schemas.microsoft.com/office/drawing/2014/main" id="{9F1C152C-E889-4E62-9177-DD98BCABE568}"/>
                      </a:ext>
                    </a:extLst>
                  </p:cNvPr>
                  <p:cNvGrpSpPr/>
                  <p:nvPr/>
                </p:nvGrpSpPr>
                <p:grpSpPr>
                  <a:xfrm>
                    <a:off x="6572688" y="20209"/>
                    <a:ext cx="1804769" cy="6427571"/>
                    <a:chOff x="-4988" y="18191"/>
                    <a:chExt cx="1759760" cy="6981071"/>
                  </a:xfrm>
                </p:grpSpPr>
                <p:pic>
                  <p:nvPicPr>
                    <p:cNvPr id="30" name="Picture 29">
                      <a:extLst>
                        <a:ext uri="{FF2B5EF4-FFF2-40B4-BE49-F238E27FC236}">
                          <a16:creationId xmlns:a16="http://schemas.microsoft.com/office/drawing/2014/main" id="{94893356-19C5-4450-8EB4-44758F27EFB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8"/>
                    <a:stretch>
                      <a:fillRect/>
                    </a:stretch>
                  </p:blipFill>
                  <p:spPr>
                    <a:xfrm>
                      <a:off x="16116" y="5228007"/>
                      <a:ext cx="1733668" cy="177125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1" name="Picture 30">
                      <a:extLst>
                        <a:ext uri="{FF2B5EF4-FFF2-40B4-BE49-F238E27FC236}">
                          <a16:creationId xmlns:a16="http://schemas.microsoft.com/office/drawing/2014/main" id="{899FA985-58E3-42F4-9936-B575145FB04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9"/>
                    <a:stretch>
                      <a:fillRect/>
                    </a:stretch>
                  </p:blipFill>
                  <p:spPr>
                    <a:xfrm>
                      <a:off x="16116" y="3432204"/>
                      <a:ext cx="1733668" cy="182057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2" name="Picture 31">
                      <a:extLst>
                        <a:ext uri="{FF2B5EF4-FFF2-40B4-BE49-F238E27FC236}">
                          <a16:creationId xmlns:a16="http://schemas.microsoft.com/office/drawing/2014/main" id="{B66DCA5E-9827-4B74-9E31-CFB64B4604D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0"/>
                    <a:stretch>
                      <a:fillRect/>
                    </a:stretch>
                  </p:blipFill>
                  <p:spPr>
                    <a:xfrm>
                      <a:off x="-4988" y="1718296"/>
                      <a:ext cx="1754772" cy="1736584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3" name="Picture 32">
                      <a:extLst>
                        <a:ext uri="{FF2B5EF4-FFF2-40B4-BE49-F238E27FC236}">
                          <a16:creationId xmlns:a16="http://schemas.microsoft.com/office/drawing/2014/main" id="{1CF34B1E-92AC-44DB-8E59-0958FF6143A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1"/>
                    <a:stretch>
                      <a:fillRect/>
                    </a:stretch>
                  </p:blipFill>
                  <p:spPr>
                    <a:xfrm>
                      <a:off x="0" y="18191"/>
                      <a:ext cx="1754772" cy="1727354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20" name="Group 19">
                    <a:extLst>
                      <a:ext uri="{FF2B5EF4-FFF2-40B4-BE49-F238E27FC236}">
                        <a16:creationId xmlns:a16="http://schemas.microsoft.com/office/drawing/2014/main" id="{0B74EC48-BDF6-488B-9840-2F7DE6B3DB8C}"/>
                      </a:ext>
                    </a:extLst>
                  </p:cNvPr>
                  <p:cNvGrpSpPr/>
                  <p:nvPr/>
                </p:nvGrpSpPr>
                <p:grpSpPr>
                  <a:xfrm>
                    <a:off x="8340593" y="20288"/>
                    <a:ext cx="1900925" cy="6420040"/>
                    <a:chOff x="72894" y="273106"/>
                    <a:chExt cx="1796964" cy="6352253"/>
                  </a:xfrm>
                </p:grpSpPr>
                <p:pic>
                  <p:nvPicPr>
                    <p:cNvPr id="26" name="Picture 25">
                      <a:extLst>
                        <a:ext uri="{FF2B5EF4-FFF2-40B4-BE49-F238E27FC236}">
                          <a16:creationId xmlns:a16="http://schemas.microsoft.com/office/drawing/2014/main" id="{EF1B9AB2-A1CB-46AD-BEB9-DD36820A59F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2"/>
                    <a:stretch>
                      <a:fillRect/>
                    </a:stretch>
                  </p:blipFill>
                  <p:spPr>
                    <a:xfrm>
                      <a:off x="72894" y="273106"/>
                      <a:ext cx="1711560" cy="158782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7" name="Picture 26">
                      <a:extLst>
                        <a:ext uri="{FF2B5EF4-FFF2-40B4-BE49-F238E27FC236}">
                          <a16:creationId xmlns:a16="http://schemas.microsoft.com/office/drawing/2014/main" id="{17F1DFE6-02AF-4819-B99D-073F3C122D1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3"/>
                    <a:stretch>
                      <a:fillRect/>
                    </a:stretch>
                  </p:blipFill>
                  <p:spPr>
                    <a:xfrm>
                      <a:off x="93683" y="5053748"/>
                      <a:ext cx="1776175" cy="157161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8" name="Picture 27">
                      <a:extLst>
                        <a:ext uri="{FF2B5EF4-FFF2-40B4-BE49-F238E27FC236}">
                          <a16:creationId xmlns:a16="http://schemas.microsoft.com/office/drawing/2014/main" id="{555EC97E-CDA2-43F0-B8EE-DDD63494410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4"/>
                    <a:stretch>
                      <a:fillRect/>
                    </a:stretch>
                  </p:blipFill>
                  <p:spPr>
                    <a:xfrm>
                      <a:off x="98190" y="1831607"/>
                      <a:ext cx="1711560" cy="1551333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9" name="Picture 28">
                      <a:extLst>
                        <a:ext uri="{FF2B5EF4-FFF2-40B4-BE49-F238E27FC236}">
                          <a16:creationId xmlns:a16="http://schemas.microsoft.com/office/drawing/2014/main" id="{86379C9B-E30D-48D2-9F5F-A91AB45200E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5"/>
                    <a:stretch>
                      <a:fillRect/>
                    </a:stretch>
                  </p:blipFill>
                  <p:spPr>
                    <a:xfrm>
                      <a:off x="107289" y="3351129"/>
                      <a:ext cx="1748965" cy="1679283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34650360-B47D-4C65-AE80-1CAE1C1218B2}"/>
                      </a:ext>
                    </a:extLst>
                  </p:cNvPr>
                  <p:cNvGrpSpPr/>
                  <p:nvPr/>
                </p:nvGrpSpPr>
                <p:grpSpPr>
                  <a:xfrm>
                    <a:off x="10190956" y="14992"/>
                    <a:ext cx="1915319" cy="6425335"/>
                    <a:chOff x="-57933" y="-52953"/>
                    <a:chExt cx="1814863" cy="7060852"/>
                  </a:xfrm>
                </p:grpSpPr>
                <p:pic>
                  <p:nvPicPr>
                    <p:cNvPr id="22" name="Picture 21">
                      <a:extLst>
                        <a:ext uri="{FF2B5EF4-FFF2-40B4-BE49-F238E27FC236}">
                          <a16:creationId xmlns:a16="http://schemas.microsoft.com/office/drawing/2014/main" id="{076350C5-1C24-4817-8FD5-F62212DC1AA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6"/>
                    <a:stretch>
                      <a:fillRect/>
                    </a:stretch>
                  </p:blipFill>
                  <p:spPr>
                    <a:xfrm>
                      <a:off x="-57933" y="1658754"/>
                      <a:ext cx="1758788" cy="1763496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3" name="Picture 22">
                      <a:extLst>
                        <a:ext uri="{FF2B5EF4-FFF2-40B4-BE49-F238E27FC236}">
                          <a16:creationId xmlns:a16="http://schemas.microsoft.com/office/drawing/2014/main" id="{88B6748A-74EF-491E-8E18-1459499A335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7"/>
                    <a:stretch>
                      <a:fillRect/>
                    </a:stretch>
                  </p:blipFill>
                  <p:spPr>
                    <a:xfrm>
                      <a:off x="-57933" y="-52953"/>
                      <a:ext cx="1758788" cy="174770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4" name="Picture 23">
                      <a:extLst>
                        <a:ext uri="{FF2B5EF4-FFF2-40B4-BE49-F238E27FC236}">
                          <a16:creationId xmlns:a16="http://schemas.microsoft.com/office/drawing/2014/main" id="{0CC01372-46AE-4445-A82F-0BD864AC798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8"/>
                    <a:stretch>
                      <a:fillRect/>
                    </a:stretch>
                  </p:blipFill>
                  <p:spPr>
                    <a:xfrm>
                      <a:off x="-16428" y="5287169"/>
                      <a:ext cx="1758788" cy="172073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5" name="Picture 24">
                      <a:extLst>
                        <a:ext uri="{FF2B5EF4-FFF2-40B4-BE49-F238E27FC236}">
                          <a16:creationId xmlns:a16="http://schemas.microsoft.com/office/drawing/2014/main" id="{B765CC1E-BDE8-430D-A1C2-85EA09E5528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9"/>
                    <a:stretch>
                      <a:fillRect/>
                    </a:stretch>
                  </p:blipFill>
                  <p:spPr>
                    <a:xfrm>
                      <a:off x="-1858" y="3380040"/>
                      <a:ext cx="1758788" cy="1865070"/>
                    </a:xfrm>
                    <a:prstGeom prst="rect">
                      <a:avLst/>
                    </a:prstGeom>
                  </p:spPr>
                </p:pic>
              </p:grpSp>
            </p:grp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D287F63C-ADD5-4985-8787-0CA50A7BE261}"/>
                    </a:ext>
                  </a:extLst>
                </p:cNvPr>
                <p:cNvSpPr txBox="1"/>
                <p:nvPr/>
              </p:nvSpPr>
              <p:spPr>
                <a:xfrm>
                  <a:off x="-47625" y="142875"/>
                  <a:ext cx="429969" cy="2206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6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[A]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B42DBF59-AFFD-4195-8814-B97DF29FB1FA}"/>
                    </a:ext>
                  </a:extLst>
                </p:cNvPr>
                <p:cNvSpPr txBox="1"/>
                <p:nvPr/>
              </p:nvSpPr>
              <p:spPr>
                <a:xfrm>
                  <a:off x="9525" y="1600200"/>
                  <a:ext cx="429970" cy="2206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6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[B]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22D461F7-3A6C-4AD1-8F5F-C426574EF70A}"/>
                    </a:ext>
                  </a:extLst>
                </p:cNvPr>
                <p:cNvSpPr txBox="1"/>
                <p:nvPr/>
              </p:nvSpPr>
              <p:spPr>
                <a:xfrm>
                  <a:off x="-28576" y="3209925"/>
                  <a:ext cx="410919" cy="2206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6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[C]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70B847CE-3E74-4686-869A-24BFEA379A4D}"/>
                    </a:ext>
                  </a:extLst>
                </p:cNvPr>
                <p:cNvSpPr txBox="1"/>
                <p:nvPr/>
              </p:nvSpPr>
              <p:spPr>
                <a:xfrm>
                  <a:off x="-28575" y="4962525"/>
                  <a:ext cx="410918" cy="2206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6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[D]</a:t>
                  </a:r>
                </a:p>
              </p:txBody>
            </p:sp>
          </p:grp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242F17E-6D37-4293-BA01-1679F9ED8B69}"/>
                  </a:ext>
                </a:extLst>
              </p:cNvPr>
              <p:cNvSpPr txBox="1"/>
              <p:nvPr/>
            </p:nvSpPr>
            <p:spPr>
              <a:xfrm>
                <a:off x="804309" y="6630585"/>
                <a:ext cx="11825841" cy="2206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6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)                                                                  (b)                                                                 (c)                                                                    (d)                                                                 (e)                                                                     (f)                                                                          (g)</a:t>
                </a:r>
              </a:p>
            </p:txBody>
          </p:sp>
        </p:grp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7718FF2E-58C6-4169-AB41-D0471421701A}"/>
                </a:ext>
              </a:extLst>
            </p:cNvPr>
            <p:cNvSpPr txBox="1"/>
            <p:nvPr/>
          </p:nvSpPr>
          <p:spPr>
            <a:xfrm>
              <a:off x="42365" y="-8604"/>
              <a:ext cx="10228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uppl Fig: 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336183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989FFFD-9179-4B88-8947-25A9C60EBF26}"/>
              </a:ext>
            </a:extLst>
          </p:cNvPr>
          <p:cNvGrpSpPr/>
          <p:nvPr/>
        </p:nvGrpSpPr>
        <p:grpSpPr>
          <a:xfrm>
            <a:off x="157375" y="346549"/>
            <a:ext cx="11623249" cy="6384446"/>
            <a:chOff x="-59269" y="-7212"/>
            <a:chExt cx="12015609" cy="686192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D775CF3-B643-3D43-CD6C-6946B53469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3481" y="36083"/>
              <a:ext cx="1390953" cy="1650988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97A28FE-1FB8-E553-4AA6-75717B591A9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05612" y="-7212"/>
              <a:ext cx="1390953" cy="1650988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5E08933-43AF-93B2-7C0A-7509046A3FC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60268" y="19148"/>
              <a:ext cx="1390953" cy="1650988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50D61DB-F9BD-82FD-3D14-D58EA252166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421341" y="-4176"/>
              <a:ext cx="1390953" cy="1650988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91CEF78-1B67-8E5E-9EAA-77287D351F9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170938" y="36083"/>
              <a:ext cx="1390953" cy="1650988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18CD836-458C-0EFD-D4FC-19A5E20A076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812215" y="22209"/>
              <a:ext cx="1390953" cy="1650988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948F747-E753-C301-5B07-40DB3C21D7D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586472" y="22208"/>
              <a:ext cx="1352934" cy="160586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9DD65F2B-8FDE-38A9-A599-39BA94DC66E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24212" y="1681872"/>
              <a:ext cx="1390953" cy="1650989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CC75BC77-5790-46AF-1F8A-99250635E85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718188" y="1682781"/>
              <a:ext cx="1415318" cy="1679908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4D6C17DA-FAE9-08AB-CE03-6C4E2B443BA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010010" y="1722744"/>
              <a:ext cx="1390953" cy="1650988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66EE36BE-A2D2-8CF1-4F57-D29EA7D6344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458008" y="1693326"/>
              <a:ext cx="1411719" cy="1675636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C95D9AB5-8F2F-2332-2F93-A69080EDEE4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195542" y="1708511"/>
              <a:ext cx="1384054" cy="16428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281F99A3-4E2A-1E06-439E-64D375A78D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8856340" y="1715671"/>
              <a:ext cx="1390953" cy="1650988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23A93CE0-03D9-9502-8E2C-2C16275CA17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0603405" y="1744129"/>
              <a:ext cx="1352935" cy="1605863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51E6C1CA-A10C-D7FD-D4F6-F3EFBFBCC5EA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23947" y="3338358"/>
              <a:ext cx="1384025" cy="1556498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628AD272-F5BD-7C09-CC6D-C4268CFE3428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775316" y="3365759"/>
              <a:ext cx="1321249" cy="1568253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D0FDF92C-AF64-8419-B694-855E1714CE8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2024855" y="3362782"/>
              <a:ext cx="1355981" cy="1568254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02C72EF0-2B6E-D9B2-D753-0F94731B152A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5494284" y="3362779"/>
              <a:ext cx="1375444" cy="1568253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E4D8AAD6-4FF0-0D8A-7844-B71E5DC687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7242030" y="3380693"/>
              <a:ext cx="1337565" cy="158762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B0C9E30B-D02B-93C4-5BA9-96876185BC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8911292" y="3395127"/>
              <a:ext cx="1352936" cy="1605863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5551AAE0-4F0B-F37A-4300-61467E9074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10653148" y="3412248"/>
              <a:ext cx="1286258" cy="1526721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4DD8190C-9ACD-4145-9DE1-B59B8EFA61F2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355497" y="4996309"/>
              <a:ext cx="1297403" cy="1539949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ADEED796-E842-DD08-236D-82B112961156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3793974" y="5057000"/>
              <a:ext cx="1347998" cy="1482680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C4ED0364-B167-D634-564A-A40633595688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147969" y="5040226"/>
              <a:ext cx="1249927" cy="1483598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C7341BFA-28DA-E410-F409-F0913961AB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5508320" y="5043788"/>
              <a:ext cx="1384741" cy="1507482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261E84E4-0DCF-39F2-1AF2-B9F29B8A350E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7266192" y="5043650"/>
              <a:ext cx="1321249" cy="1568253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E594528E-EB7D-04B2-3E92-E189C4DF77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8985120" y="5064045"/>
              <a:ext cx="1301194" cy="1544449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A4DE4628-7284-345E-F5F2-CEB1657C766A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10659444" y="5064345"/>
              <a:ext cx="1249927" cy="1483598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EA6C617-4E59-212A-5893-E074BA85AEB9}"/>
                </a:ext>
              </a:extLst>
            </p:cNvPr>
            <p:cNvSpPr txBox="1"/>
            <p:nvPr/>
          </p:nvSpPr>
          <p:spPr>
            <a:xfrm>
              <a:off x="-59265" y="5751"/>
              <a:ext cx="3265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FA63534-E5F8-D309-C4D3-3AC49BD096E2}"/>
                </a:ext>
              </a:extLst>
            </p:cNvPr>
            <p:cNvSpPr txBox="1"/>
            <p:nvPr/>
          </p:nvSpPr>
          <p:spPr>
            <a:xfrm>
              <a:off x="-59266" y="1622884"/>
              <a:ext cx="3265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F876AB5-E1BD-40D0-61DD-E441A4052CAE}"/>
                </a:ext>
              </a:extLst>
            </p:cNvPr>
            <p:cNvSpPr txBox="1"/>
            <p:nvPr/>
          </p:nvSpPr>
          <p:spPr>
            <a:xfrm>
              <a:off x="-59268" y="3231550"/>
              <a:ext cx="3265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82E8A1E-0B5E-68CB-735D-C8DBEF2AB0FE}"/>
                </a:ext>
              </a:extLst>
            </p:cNvPr>
            <p:cNvSpPr txBox="1"/>
            <p:nvPr/>
          </p:nvSpPr>
          <p:spPr>
            <a:xfrm>
              <a:off x="-59269" y="4950285"/>
              <a:ext cx="3265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.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4BC9512-391F-E646-456C-8DA9E7E23681}"/>
                </a:ext>
              </a:extLst>
            </p:cNvPr>
            <p:cNvSpPr txBox="1"/>
            <p:nvPr/>
          </p:nvSpPr>
          <p:spPr>
            <a:xfrm>
              <a:off x="968105" y="6608494"/>
              <a:ext cx="3611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3CBCF46-C883-C099-0D1B-51497A2BFDFA}"/>
                </a:ext>
              </a:extLst>
            </p:cNvPr>
            <p:cNvSpPr txBox="1"/>
            <p:nvPr/>
          </p:nvSpPr>
          <p:spPr>
            <a:xfrm>
              <a:off x="2746107" y="6600027"/>
              <a:ext cx="3858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5F1C3B2-9810-BCB6-2FE4-214197330D42}"/>
                </a:ext>
              </a:extLst>
            </p:cNvPr>
            <p:cNvSpPr txBox="1"/>
            <p:nvPr/>
          </p:nvSpPr>
          <p:spPr>
            <a:xfrm>
              <a:off x="4439443" y="6600023"/>
              <a:ext cx="368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83E7FD5-3240-1230-DB03-BB371C5EC002}"/>
                </a:ext>
              </a:extLst>
            </p:cNvPr>
            <p:cNvSpPr txBox="1"/>
            <p:nvPr/>
          </p:nvSpPr>
          <p:spPr>
            <a:xfrm>
              <a:off x="6192045" y="6600020"/>
              <a:ext cx="368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0C82BF5-4A5F-A22D-1A8F-E5AD1895FF56}"/>
                </a:ext>
              </a:extLst>
            </p:cNvPr>
            <p:cNvSpPr txBox="1"/>
            <p:nvPr/>
          </p:nvSpPr>
          <p:spPr>
            <a:xfrm>
              <a:off x="7910779" y="6600018"/>
              <a:ext cx="368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e)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2073EF8-8943-118F-E842-BA4443B6C3B5}"/>
                </a:ext>
              </a:extLst>
            </p:cNvPr>
            <p:cNvSpPr txBox="1"/>
            <p:nvPr/>
          </p:nvSpPr>
          <p:spPr>
            <a:xfrm>
              <a:off x="9621047" y="6600015"/>
              <a:ext cx="3272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f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40C9BFA-B202-62AE-50FC-F692A2813E26}"/>
                </a:ext>
              </a:extLst>
            </p:cNvPr>
            <p:cNvSpPr txBox="1"/>
            <p:nvPr/>
          </p:nvSpPr>
          <p:spPr>
            <a:xfrm>
              <a:off x="11255114" y="6600011"/>
              <a:ext cx="368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g)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A7C9AABF-0110-4D65-9AC8-735FD1E65B26}"/>
              </a:ext>
            </a:extLst>
          </p:cNvPr>
          <p:cNvSpPr txBox="1"/>
          <p:nvPr/>
        </p:nvSpPr>
        <p:spPr>
          <a:xfrm>
            <a:off x="199741" y="145365"/>
            <a:ext cx="1004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 Fig: 4</a:t>
            </a:r>
          </a:p>
        </p:txBody>
      </p:sp>
    </p:spTree>
    <p:extLst>
      <p:ext uri="{BB962C8B-B14F-4D97-AF65-F5344CB8AC3E}">
        <p14:creationId xmlns:p14="http://schemas.microsoft.com/office/powerpoint/2010/main" val="32942452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946FCBE9-2A56-4D09-93AF-258F95982165}"/>
              </a:ext>
            </a:extLst>
          </p:cNvPr>
          <p:cNvGrpSpPr/>
          <p:nvPr/>
        </p:nvGrpSpPr>
        <p:grpSpPr>
          <a:xfrm>
            <a:off x="3684322" y="972422"/>
            <a:ext cx="4617187" cy="5092609"/>
            <a:chOff x="3078790" y="1084938"/>
            <a:chExt cx="5066054" cy="5089663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E4C3104-C774-47F1-9FD2-94468B0F18FD}"/>
                </a:ext>
              </a:extLst>
            </p:cNvPr>
            <p:cNvSpPr txBox="1"/>
            <p:nvPr/>
          </p:nvSpPr>
          <p:spPr>
            <a:xfrm>
              <a:off x="3078790" y="1084938"/>
              <a:ext cx="576064" cy="2460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42900"/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95E1791-F97A-4814-97EF-383147FDAD63}"/>
                </a:ext>
              </a:extLst>
            </p:cNvPr>
            <p:cNvSpPr txBox="1"/>
            <p:nvPr/>
          </p:nvSpPr>
          <p:spPr>
            <a:xfrm>
              <a:off x="5963105" y="1091585"/>
              <a:ext cx="576064" cy="2460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42900"/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ABD6548-5286-4D55-93A6-B9B00EED5529}"/>
                </a:ext>
              </a:extLst>
            </p:cNvPr>
            <p:cNvSpPr txBox="1"/>
            <p:nvPr/>
          </p:nvSpPr>
          <p:spPr>
            <a:xfrm>
              <a:off x="3269648" y="3615973"/>
              <a:ext cx="576064" cy="2460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42900"/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3FDD639-7709-4923-8142-389DC0C1D5B4}"/>
                </a:ext>
              </a:extLst>
            </p:cNvPr>
            <p:cNvSpPr txBox="1"/>
            <p:nvPr/>
          </p:nvSpPr>
          <p:spPr>
            <a:xfrm>
              <a:off x="5963106" y="3647859"/>
              <a:ext cx="576064" cy="2460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42900"/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</a:p>
          </p:txBody>
        </p:sp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4D9604A3-561A-4CA2-9B9C-F180F2E6F51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243062" y="1343766"/>
            <a:ext cx="1960859" cy="20558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0" name="Prism 8" r:id="rId3" imgW="2552436" imgH="3308407" progId="Prism8.Document">
                    <p:embed/>
                  </p:oleObj>
                </mc:Choice>
                <mc:Fallback>
                  <p:oleObj name="Prism 8" r:id="rId3" imgW="2552436" imgH="3308407" progId="Prism8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4D9604A3-561A-4CA2-9B9C-F180F2E6F51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243062" y="1343766"/>
                          <a:ext cx="1960859" cy="20558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657ABA55-EA62-4079-87C8-AC9EABD0052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096000" y="1343766"/>
            <a:ext cx="1953615" cy="22140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1" name="Prism 8" r:id="rId5" imgW="2499163" imgH="3113308" progId="Prism8.Document">
                    <p:embed/>
                  </p:oleObj>
                </mc:Choice>
                <mc:Fallback>
                  <p:oleObj name="Prism 8" r:id="rId5" imgW="2499163" imgH="3113308" progId="Prism8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657ABA55-EA62-4079-87C8-AC9EABD0052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096000" y="1343766"/>
                          <a:ext cx="1953615" cy="22140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7BDD331D-6225-45ED-9112-D01CD09C461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242688" y="3950563"/>
            <a:ext cx="2066159" cy="20558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2" name="Prism 8" r:id="rId7" imgW="2511401" imgH="3197179" progId="Prism8.Document">
                    <p:embed/>
                  </p:oleObj>
                </mc:Choice>
                <mc:Fallback>
                  <p:oleObj name="Prism 8" r:id="rId7" imgW="2511401" imgH="3197179" progId="Prism8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7BDD331D-6225-45ED-9112-D01CD09C461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242688" y="3950563"/>
                          <a:ext cx="2066159" cy="20558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DA8F4D07-478D-48E1-ACFA-1D03B7759C1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7368068"/>
                </p:ext>
              </p:extLst>
            </p:nvPr>
          </p:nvGraphicFramePr>
          <p:xfrm>
            <a:off x="6191229" y="3960503"/>
            <a:ext cx="1953615" cy="221409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3" name="Prism 8" r:id="rId9" imgW="2483685" imgH="3113308" progId="Prism8.Document">
                    <p:embed/>
                  </p:oleObj>
                </mc:Choice>
                <mc:Fallback>
                  <p:oleObj name="Prism 8" r:id="rId9" imgW="2483685" imgH="3113308" progId="Prism8.Document">
                    <p:embed/>
                    <p:pic>
                      <p:nvPicPr>
                        <p:cNvPr id="14" name="Object 13">
                          <a:extLst>
                            <a:ext uri="{FF2B5EF4-FFF2-40B4-BE49-F238E27FC236}">
                              <a16:creationId xmlns:a16="http://schemas.microsoft.com/office/drawing/2014/main" id="{DA8F4D07-478D-48E1-ACFA-1D03B7759C1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6191229" y="3960503"/>
                          <a:ext cx="1953615" cy="221409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CC689003-ED82-9F83-6B71-6C7989668837}"/>
              </a:ext>
            </a:extLst>
          </p:cNvPr>
          <p:cNvSpPr txBox="1"/>
          <p:nvPr/>
        </p:nvSpPr>
        <p:spPr>
          <a:xfrm>
            <a:off x="2073166" y="664540"/>
            <a:ext cx="11555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42900"/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 Fig : 5</a:t>
            </a:r>
          </a:p>
        </p:txBody>
      </p:sp>
    </p:spTree>
    <p:extLst>
      <p:ext uri="{BB962C8B-B14F-4D97-AF65-F5344CB8AC3E}">
        <p14:creationId xmlns:p14="http://schemas.microsoft.com/office/powerpoint/2010/main" val="337092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125357-CDF0-4C06-B010-064DBA02D67F}"/>
              </a:ext>
            </a:extLst>
          </p:cNvPr>
          <p:cNvSpPr txBox="1"/>
          <p:nvPr/>
        </p:nvSpPr>
        <p:spPr>
          <a:xfrm>
            <a:off x="3406302" y="6471752"/>
            <a:ext cx="2546215" cy="222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IN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Small protein amino acid residue of present study</a:t>
            </a:r>
            <a:endParaRPr lang="en-US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173958D-EF65-4037-98E9-08F09B0AC1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1328568"/>
              </p:ext>
            </p:extLst>
          </p:nvPr>
        </p:nvGraphicFramePr>
        <p:xfrm>
          <a:off x="3406302" y="521147"/>
          <a:ext cx="5379397" cy="5974080"/>
        </p:xfrm>
        <a:graphic>
          <a:graphicData uri="http://schemas.openxmlformats.org/drawingml/2006/table">
            <a:tbl>
              <a:tblPr firstRow="1" firstCol="1" bandRow="1"/>
              <a:tblGrid>
                <a:gridCol w="933196">
                  <a:extLst>
                    <a:ext uri="{9D8B030D-6E8A-4147-A177-3AD203B41FA5}">
                      <a16:colId xmlns:a16="http://schemas.microsoft.com/office/drawing/2014/main" val="2992483431"/>
                    </a:ext>
                  </a:extLst>
                </a:gridCol>
                <a:gridCol w="592022">
                  <a:extLst>
                    <a:ext uri="{9D8B030D-6E8A-4147-A177-3AD203B41FA5}">
                      <a16:colId xmlns:a16="http://schemas.microsoft.com/office/drawing/2014/main" val="543798569"/>
                    </a:ext>
                  </a:extLst>
                </a:gridCol>
                <a:gridCol w="617912">
                  <a:extLst>
                    <a:ext uri="{9D8B030D-6E8A-4147-A177-3AD203B41FA5}">
                      <a16:colId xmlns:a16="http://schemas.microsoft.com/office/drawing/2014/main" val="2398955087"/>
                    </a:ext>
                  </a:extLst>
                </a:gridCol>
                <a:gridCol w="911355">
                  <a:extLst>
                    <a:ext uri="{9D8B030D-6E8A-4147-A177-3AD203B41FA5}">
                      <a16:colId xmlns:a16="http://schemas.microsoft.com/office/drawing/2014/main" val="1907649254"/>
                    </a:ext>
                  </a:extLst>
                </a:gridCol>
                <a:gridCol w="629971">
                  <a:extLst>
                    <a:ext uri="{9D8B030D-6E8A-4147-A177-3AD203B41FA5}">
                      <a16:colId xmlns:a16="http://schemas.microsoft.com/office/drawing/2014/main" val="2447894515"/>
                    </a:ext>
                  </a:extLst>
                </a:gridCol>
                <a:gridCol w="741608">
                  <a:extLst>
                    <a:ext uri="{9D8B030D-6E8A-4147-A177-3AD203B41FA5}">
                      <a16:colId xmlns:a16="http://schemas.microsoft.com/office/drawing/2014/main" val="3456301711"/>
                    </a:ext>
                  </a:extLst>
                </a:gridCol>
                <a:gridCol w="555200">
                  <a:extLst>
                    <a:ext uri="{9D8B030D-6E8A-4147-A177-3AD203B41FA5}">
                      <a16:colId xmlns:a16="http://schemas.microsoft.com/office/drawing/2014/main" val="1583578770"/>
                    </a:ext>
                  </a:extLst>
                </a:gridCol>
                <a:gridCol w="398133">
                  <a:extLst>
                    <a:ext uri="{9D8B030D-6E8A-4147-A177-3AD203B41FA5}">
                      <a16:colId xmlns:a16="http://schemas.microsoft.com/office/drawing/2014/main" val="3498251340"/>
                    </a:ext>
                  </a:extLst>
                </a:gridCol>
              </a:tblGrid>
              <a:tr h="84106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itopes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ition in sequence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bined Score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Proteosome, TAP, MHCI binding)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teraction of MHC-I allele IC50 value of &lt;200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mmunogenicity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geni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lergen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xi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1909099"/>
                  </a:ext>
                </a:extLst>
              </a:tr>
              <a:tr h="84106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GTNGTKRFDN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5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23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24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30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30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2:03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2:06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1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3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27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9948511"/>
                  </a:ext>
                </a:extLst>
              </a:tr>
              <a:tr h="52566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SSSGWTAG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2:06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2:03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1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11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3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3881344"/>
                  </a:ext>
                </a:extLst>
              </a:tr>
              <a:tr h="63079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QSAPHGVVF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*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23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B*15:25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B*15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B*15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C*03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C*16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2:06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7674557"/>
                  </a:ext>
                </a:extLst>
              </a:tr>
              <a:tr h="42053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VVFLHVTY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*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29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2:06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B*15:25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C*12:03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0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8120176"/>
                  </a:ext>
                </a:extLst>
              </a:tr>
              <a:tr h="52566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VSNGTHWF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6*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6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B*35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B*15:25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B*15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2:06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C*12:03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2566368"/>
                  </a:ext>
                </a:extLst>
              </a:tr>
              <a:tr h="42053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SNGTHWFV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7*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57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C*12:03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2:06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68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02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5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1218221"/>
                  </a:ext>
                </a:extLst>
              </a:tr>
              <a:tr h="52566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THWFVTQR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*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20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31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68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11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74:0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C*12:03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5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8790305"/>
                  </a:ext>
                </a:extLst>
              </a:tr>
              <a:tr h="42053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FVTQRNFY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*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564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A*29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C*14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C*12:03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LA-B*15:0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952" marR="4995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8400853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1D22806E-759E-4C4F-8897-EA6CE0D02FF6}"/>
              </a:ext>
            </a:extLst>
          </p:cNvPr>
          <p:cNvSpPr txBox="1"/>
          <p:nvPr/>
        </p:nvSpPr>
        <p:spPr>
          <a:xfrm>
            <a:off x="4307327" y="163809"/>
            <a:ext cx="3577347" cy="222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. Table 1: Characteristics of predicted Cytotoxic T-cell epitopes.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6170729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C33832B-9B51-4625-AD6A-910AEE7DFF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1768452"/>
              </p:ext>
            </p:extLst>
          </p:nvPr>
        </p:nvGraphicFramePr>
        <p:xfrm>
          <a:off x="3692843" y="2201704"/>
          <a:ext cx="4806315" cy="3754821"/>
        </p:xfrm>
        <a:graphic>
          <a:graphicData uri="http://schemas.openxmlformats.org/drawingml/2006/table">
            <a:tbl>
              <a:tblPr/>
              <a:tblGrid>
                <a:gridCol w="1564640">
                  <a:extLst>
                    <a:ext uri="{9D8B030D-6E8A-4147-A177-3AD203B41FA5}">
                      <a16:colId xmlns:a16="http://schemas.microsoft.com/office/drawing/2014/main" val="1728587755"/>
                    </a:ext>
                  </a:extLst>
                </a:gridCol>
                <a:gridCol w="544830">
                  <a:extLst>
                    <a:ext uri="{9D8B030D-6E8A-4147-A177-3AD203B41FA5}">
                      <a16:colId xmlns:a16="http://schemas.microsoft.com/office/drawing/2014/main" val="722900178"/>
                    </a:ext>
                  </a:extLst>
                </a:gridCol>
                <a:gridCol w="1045845">
                  <a:extLst>
                    <a:ext uri="{9D8B030D-6E8A-4147-A177-3AD203B41FA5}">
                      <a16:colId xmlns:a16="http://schemas.microsoft.com/office/drawing/2014/main" val="2139342778"/>
                    </a:ext>
                  </a:extLst>
                </a:gridCol>
                <a:gridCol w="650240">
                  <a:extLst>
                    <a:ext uri="{9D8B030D-6E8A-4147-A177-3AD203B41FA5}">
                      <a16:colId xmlns:a16="http://schemas.microsoft.com/office/drawing/2014/main" val="501956632"/>
                    </a:ext>
                  </a:extLst>
                </a:gridCol>
                <a:gridCol w="585470">
                  <a:extLst>
                    <a:ext uri="{9D8B030D-6E8A-4147-A177-3AD203B41FA5}">
                      <a16:colId xmlns:a16="http://schemas.microsoft.com/office/drawing/2014/main" val="1055188884"/>
                    </a:ext>
                  </a:extLst>
                </a:gridCol>
                <a:gridCol w="415290">
                  <a:extLst>
                    <a:ext uri="{9D8B030D-6E8A-4147-A177-3AD203B41FA5}">
                      <a16:colId xmlns:a16="http://schemas.microsoft.com/office/drawing/2014/main" val="1691572825"/>
                    </a:ext>
                  </a:extLst>
                </a:gridCol>
              </a:tblGrid>
              <a:tr h="5962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top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eraction of MHCII alleles having IC50 value &lt; 200nm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tigeni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lerge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xi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1285528"/>
                  </a:ext>
                </a:extLst>
              </a:tr>
              <a:tr h="5962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GTNGTKRFD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3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07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5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3*02: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15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5056876"/>
                  </a:ext>
                </a:extLst>
              </a:tr>
              <a:tr h="63119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SSSGWTA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3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07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3*02: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5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15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9167666"/>
                  </a:ext>
                </a:extLst>
              </a:tr>
              <a:tr h="2597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SFPQSAPHGVVF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07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2419352"/>
                  </a:ext>
                </a:extLst>
              </a:tr>
              <a:tr h="74549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GVVFLHVTYVPAQ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04: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07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04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15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5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168519"/>
                  </a:ext>
                </a:extLst>
              </a:tr>
              <a:tr h="12255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GTHWFVTQRNFY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5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9257261"/>
                  </a:ext>
                </a:extLst>
              </a:tr>
              <a:tr h="6654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GVFVSNGTHWFV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3*02: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3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07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1*15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LA-DRB5*01: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560" marR="3556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8133712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8E98A682-2A54-4F3E-AD5A-BD52EF5F31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92843" y="5956525"/>
            <a:ext cx="2484976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Small protein amino acid residue of present study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D7AADAA-1A8B-4817-BBAC-7C524A53C79D}"/>
              </a:ext>
            </a:extLst>
          </p:cNvPr>
          <p:cNvSpPr txBox="1"/>
          <p:nvPr/>
        </p:nvSpPr>
        <p:spPr>
          <a:xfrm>
            <a:off x="4390012" y="1816983"/>
            <a:ext cx="341197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IN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. Table 2: Characteristics of Helper T Lymphocyte Epitopes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IN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73999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C931518-10FA-4177-BD92-3615050B12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1654063"/>
              </p:ext>
            </p:extLst>
          </p:nvPr>
        </p:nvGraphicFramePr>
        <p:xfrm>
          <a:off x="3297798" y="2161792"/>
          <a:ext cx="5596404" cy="3548344"/>
        </p:xfrm>
        <a:graphic>
          <a:graphicData uri="http://schemas.openxmlformats.org/drawingml/2006/table">
            <a:tbl>
              <a:tblPr firstRow="1" firstCol="1" bandRow="1"/>
              <a:tblGrid>
                <a:gridCol w="409253">
                  <a:extLst>
                    <a:ext uri="{9D8B030D-6E8A-4147-A177-3AD203B41FA5}">
                      <a16:colId xmlns:a16="http://schemas.microsoft.com/office/drawing/2014/main" val="462722158"/>
                    </a:ext>
                  </a:extLst>
                </a:gridCol>
                <a:gridCol w="886705">
                  <a:extLst>
                    <a:ext uri="{9D8B030D-6E8A-4147-A177-3AD203B41FA5}">
                      <a16:colId xmlns:a16="http://schemas.microsoft.com/office/drawing/2014/main" val="830260501"/>
                    </a:ext>
                  </a:extLst>
                </a:gridCol>
                <a:gridCol w="516386">
                  <a:extLst>
                    <a:ext uri="{9D8B030D-6E8A-4147-A177-3AD203B41FA5}">
                      <a16:colId xmlns:a16="http://schemas.microsoft.com/office/drawing/2014/main" val="1252860102"/>
                    </a:ext>
                  </a:extLst>
                </a:gridCol>
                <a:gridCol w="486383">
                  <a:extLst>
                    <a:ext uri="{9D8B030D-6E8A-4147-A177-3AD203B41FA5}">
                      <a16:colId xmlns:a16="http://schemas.microsoft.com/office/drawing/2014/main" val="616031327"/>
                    </a:ext>
                  </a:extLst>
                </a:gridCol>
                <a:gridCol w="1144844">
                  <a:extLst>
                    <a:ext uri="{9D8B030D-6E8A-4147-A177-3AD203B41FA5}">
                      <a16:colId xmlns:a16="http://schemas.microsoft.com/office/drawing/2014/main" val="2594227888"/>
                    </a:ext>
                  </a:extLst>
                </a:gridCol>
                <a:gridCol w="2152833">
                  <a:extLst>
                    <a:ext uri="{9D8B030D-6E8A-4147-A177-3AD203B41FA5}">
                      <a16:colId xmlns:a16="http://schemas.microsoft.com/office/drawing/2014/main" val="4071718526"/>
                    </a:ext>
                  </a:extLst>
                </a:gridCol>
              </a:tblGrid>
              <a:tr h="106432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. No.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ticipants Cod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de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Years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id-19 Positive/Nega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ccine Covishield/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xin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085302"/>
                  </a:ext>
                </a:extLst>
              </a:tr>
              <a:tr h="20852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xi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2661477"/>
                  </a:ext>
                </a:extLst>
              </a:tr>
              <a:tr h="20852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x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7206656"/>
                  </a:ext>
                </a:extLst>
              </a:tr>
              <a:tr h="20852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x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7279279"/>
                  </a:ext>
                </a:extLst>
              </a:tr>
              <a:tr h="20852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4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ishiel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1677456"/>
                  </a:ext>
                </a:extLst>
              </a:tr>
              <a:tr h="20852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x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709673"/>
                  </a:ext>
                </a:extLst>
              </a:tr>
              <a:tr h="21395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6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xi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0377593"/>
                  </a:ext>
                </a:extLst>
              </a:tr>
              <a:tr h="20852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7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x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3365736"/>
                  </a:ext>
                </a:extLst>
              </a:tr>
              <a:tr h="20852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ishiel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6734946"/>
                  </a:ext>
                </a:extLst>
              </a:tr>
              <a:tr h="2335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ishiel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7647662"/>
                  </a:ext>
                </a:extLst>
              </a:tr>
              <a:tr h="20852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1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xi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0433352"/>
                  </a:ext>
                </a:extLst>
              </a:tr>
              <a:tr h="20852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1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axi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3668230"/>
                  </a:ext>
                </a:extLst>
              </a:tr>
              <a:tr h="15988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CoV2-1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8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ishiel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8819280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1DFE022D-18F1-4BE9-8806-DD195BE26ACD}"/>
              </a:ext>
            </a:extLst>
          </p:cNvPr>
          <p:cNvSpPr txBox="1"/>
          <p:nvPr/>
        </p:nvSpPr>
        <p:spPr>
          <a:xfrm>
            <a:off x="3917471" y="1714779"/>
            <a:ext cx="435705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 Table 3: Information of participants involved in the study for PBMC isolation.</a:t>
            </a:r>
            <a:endParaRPr lang="en-US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497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795</Words>
  <Application>Microsoft Office PowerPoint</Application>
  <PresentationFormat>Widescreen</PresentationFormat>
  <Paragraphs>498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8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1_Office Theme</vt:lpstr>
      <vt:lpstr>Prism 8</vt:lpstr>
      <vt:lpstr>GraphPad Prism 8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 Venkataramana</dc:creator>
  <cp:lastModifiedBy>Lenovo</cp:lastModifiedBy>
  <cp:revision>11</cp:revision>
  <dcterms:created xsi:type="dcterms:W3CDTF">2023-03-08T06:16:02Z</dcterms:created>
  <dcterms:modified xsi:type="dcterms:W3CDTF">2024-04-27T07:29:24Z</dcterms:modified>
</cp:coreProperties>
</file>